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sldIdLst>
    <p:sldId id="256" r:id="rId5"/>
    <p:sldId id="276" r:id="rId6"/>
    <p:sldId id="281" r:id="rId7"/>
    <p:sldId id="271" r:id="rId8"/>
    <p:sldId id="268" r:id="rId9"/>
    <p:sldId id="269" r:id="rId10"/>
    <p:sldId id="274" r:id="rId11"/>
  </p:sldIdLst>
  <p:sldSz cx="7559675" cy="10691813"/>
  <p:notesSz cx="6810375" cy="99425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90" userDrawn="1">
          <p15:clr>
            <a:srgbClr val="A4A3A4"/>
          </p15:clr>
        </p15:guide>
        <p15:guide id="2" pos="23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03" autoAdjust="0"/>
    <p:restoredTop sz="94665"/>
  </p:normalViewPr>
  <p:slideViewPr>
    <p:cSldViewPr snapToGrid="0" snapToObjects="1" showGuides="1">
      <p:cViewPr>
        <p:scale>
          <a:sx n="68" d="100"/>
          <a:sy n="68" d="100"/>
        </p:scale>
        <p:origin x="1452" y="-580"/>
      </p:cViewPr>
      <p:guideLst>
        <p:guide orient="horz" pos="3390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350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90BEB-A73E-0247-885A-2D45E6448EFF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77AE24-2F6A-5148-9405-5C16200C94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54914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90BEB-A73E-0247-885A-2D45E6448EFF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77AE24-2F6A-5148-9405-5C16200C94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5827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90BEB-A73E-0247-885A-2D45E6448EFF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77AE24-2F6A-5148-9405-5C16200C94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04308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90BEB-A73E-0247-885A-2D45E6448EFF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77AE24-2F6A-5148-9405-5C16200C94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2010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90BEB-A73E-0247-885A-2D45E6448EFF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77AE24-2F6A-5148-9405-5C16200C94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9673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90BEB-A73E-0247-885A-2D45E6448EFF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77AE24-2F6A-5148-9405-5C16200C94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4442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90BEB-A73E-0247-885A-2D45E6448EFF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77AE24-2F6A-5148-9405-5C16200C94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7918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90BEB-A73E-0247-885A-2D45E6448EFF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77AE24-2F6A-5148-9405-5C16200C94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03586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90BEB-A73E-0247-885A-2D45E6448EFF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77AE24-2F6A-5148-9405-5C16200C94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7429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90BEB-A73E-0247-885A-2D45E6448EFF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77AE24-2F6A-5148-9405-5C16200C94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6340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90BEB-A73E-0247-885A-2D45E6448EFF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77AE24-2F6A-5148-9405-5C16200C94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31401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C90BEB-A73E-0247-885A-2D45E6448EFF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77AE24-2F6A-5148-9405-5C16200C94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69006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6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5C96792-026D-5547-94A1-72AFEC1FA285}"/>
              </a:ext>
            </a:extLst>
          </p:cNvPr>
          <p:cNvSpPr txBox="1"/>
          <p:nvPr/>
        </p:nvSpPr>
        <p:spPr>
          <a:xfrm>
            <a:off x="126794" y="157901"/>
            <a:ext cx="3712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BB50AB8E-E712-B147-886E-9167D959871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87111255"/>
              </p:ext>
            </p:extLst>
          </p:nvPr>
        </p:nvGraphicFramePr>
        <p:xfrm>
          <a:off x="610368" y="5745849"/>
          <a:ext cx="5567743" cy="914400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130758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4669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3972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5997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11375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6410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se</a:t>
                      </a: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Level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se escalation</a:t>
                      </a:r>
                      <a:endParaRPr lang="en-GB" sz="10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Times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orts</a:t>
                      </a:r>
                    </a:p>
                    <a:p>
                      <a:pPr marL="0" marR="0" indent="0" algn="ctr" defTabSz="403671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se escalation</a:t>
                      </a:r>
                      <a:endParaRPr lang="en-GB" sz="10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Times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-0325901</a:t>
                      </a:r>
                      <a:endParaRPr lang="en-GB" sz="10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Times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izotinib</a:t>
                      </a:r>
                      <a:endParaRPr lang="en-GB" sz="1000" b="1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Times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3205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mg 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.D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1-21</a:t>
                      </a:r>
                      <a:endParaRPr lang="en-GB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0mg O.D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32053">
                <a:tc>
                  <a:txBody>
                    <a:bodyPr/>
                    <a:lstStyle/>
                    <a:p>
                      <a:pPr marL="0" marR="0" indent="0" algn="ctr" defTabSz="403671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mg 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.D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1-21</a:t>
                      </a:r>
                      <a:endParaRPr lang="en-GB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mg 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.D 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3205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mg 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.D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1-21</a:t>
                      </a:r>
                      <a:endParaRPr lang="en-GB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mg 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.D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3205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mg</a:t>
                      </a: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.D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1-21</a:t>
                      </a:r>
                      <a:endParaRPr lang="en-GB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mg 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.D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085133359"/>
                  </a:ext>
                </a:extLst>
              </a:tr>
            </a:tbl>
          </a:graphicData>
        </a:graphic>
      </p:graphicFrame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574FF0CA-C484-EF4B-8931-F0745E8E5F8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61920090"/>
              </p:ext>
            </p:extLst>
          </p:nvPr>
        </p:nvGraphicFramePr>
        <p:xfrm>
          <a:off x="618573" y="6853138"/>
          <a:ext cx="5710404" cy="625286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594360">
                  <a:extLst>
                    <a:ext uri="{9D8B030D-6E8A-4147-A177-3AD203B41FA5}">
                      <a16:colId xmlns:a16="http://schemas.microsoft.com/office/drawing/2014/main" val="1398409332"/>
                    </a:ext>
                  </a:extLst>
                </a:gridCol>
                <a:gridCol w="640878">
                  <a:extLst>
                    <a:ext uri="{9D8B030D-6E8A-4147-A177-3AD203B41FA5}">
                      <a16:colId xmlns:a16="http://schemas.microsoft.com/office/drawing/2014/main" val="2489340389"/>
                    </a:ext>
                  </a:extLst>
                </a:gridCol>
                <a:gridCol w="640878">
                  <a:extLst>
                    <a:ext uri="{9D8B030D-6E8A-4147-A177-3AD203B41FA5}">
                      <a16:colId xmlns:a16="http://schemas.microsoft.com/office/drawing/2014/main" val="696558685"/>
                    </a:ext>
                  </a:extLst>
                </a:gridCol>
                <a:gridCol w="640878">
                  <a:extLst>
                    <a:ext uri="{9D8B030D-6E8A-4147-A177-3AD203B41FA5}">
                      <a16:colId xmlns:a16="http://schemas.microsoft.com/office/drawing/2014/main" val="1603160741"/>
                    </a:ext>
                  </a:extLst>
                </a:gridCol>
                <a:gridCol w="641522">
                  <a:extLst>
                    <a:ext uri="{9D8B030D-6E8A-4147-A177-3AD203B41FA5}">
                      <a16:colId xmlns:a16="http://schemas.microsoft.com/office/drawing/2014/main" val="2508041138"/>
                    </a:ext>
                  </a:extLst>
                </a:gridCol>
                <a:gridCol w="663491">
                  <a:extLst>
                    <a:ext uri="{9D8B030D-6E8A-4147-A177-3AD203B41FA5}">
                      <a16:colId xmlns:a16="http://schemas.microsoft.com/office/drawing/2014/main" val="4159867550"/>
                    </a:ext>
                  </a:extLst>
                </a:gridCol>
                <a:gridCol w="710006">
                  <a:extLst>
                    <a:ext uri="{9D8B030D-6E8A-4147-A177-3AD203B41FA5}">
                      <a16:colId xmlns:a16="http://schemas.microsoft.com/office/drawing/2014/main" val="3350065086"/>
                    </a:ext>
                  </a:extLst>
                </a:gridCol>
                <a:gridCol w="640878">
                  <a:extLst>
                    <a:ext uri="{9D8B030D-6E8A-4147-A177-3AD203B41FA5}">
                      <a16:colId xmlns:a16="http://schemas.microsoft.com/office/drawing/2014/main" val="1748783890"/>
                    </a:ext>
                  </a:extLst>
                </a:gridCol>
                <a:gridCol w="537513">
                  <a:extLst>
                    <a:ext uri="{9D8B030D-6E8A-4147-A177-3AD203B41FA5}">
                      <a16:colId xmlns:a16="http://schemas.microsoft.com/office/drawing/2014/main" val="2323102818"/>
                    </a:ext>
                  </a:extLst>
                </a:gridCol>
              </a:tblGrid>
              <a:tr h="120952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cle 0</a:t>
                      </a:r>
                      <a:endParaRPr lang="en-GB" sz="10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cle 1</a:t>
                      </a:r>
                      <a:endParaRPr lang="en-GB" sz="10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cle 2 - 12</a:t>
                      </a:r>
                      <a:endParaRPr lang="en-GB" sz="10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35341"/>
                  </a:ext>
                </a:extLst>
              </a:tr>
              <a:tr h="110812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ek 0</a:t>
                      </a:r>
                      <a:endParaRPr lang="en-GB" sz="9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ek 1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ek 2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ek 3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ek 4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ek 1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ek 2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ek 3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ek 4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30863435"/>
                  </a:ext>
                </a:extLst>
              </a:tr>
              <a:tr h="120952">
                <a:tc gridSpan="4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-0325901 B.D dosing</a:t>
                      </a:r>
                      <a:endParaRPr lang="en-GB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-0325901 B.D dosing</a:t>
                      </a:r>
                      <a:endParaRPr lang="en-GB" sz="10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42105644"/>
                  </a:ext>
                </a:extLst>
              </a:tr>
              <a:tr h="13431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 gridSpan="8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izotinib</a:t>
                      </a: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.D or B.D dosing</a:t>
                      </a:r>
                      <a:endParaRPr lang="en-GB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36363331"/>
                  </a:ext>
                </a:extLst>
              </a:tr>
            </a:tbl>
          </a:graphicData>
        </a:graphic>
      </p:graphicFrame>
      <p:sp>
        <p:nvSpPr>
          <p:cNvPr id="11" name="Title 5">
            <a:extLst>
              <a:ext uri="{FF2B5EF4-FFF2-40B4-BE49-F238E27FC236}">
                <a16:creationId xmlns:a16="http://schemas.microsoft.com/office/drawing/2014/main" id="{A1E26514-425F-884D-A2B4-4F2E2E493AF4}"/>
              </a:ext>
            </a:extLst>
          </p:cNvPr>
          <p:cNvSpPr txBox="1">
            <a:spLocks/>
          </p:cNvSpPr>
          <p:nvPr/>
        </p:nvSpPr>
        <p:spPr>
          <a:xfrm>
            <a:off x="496639" y="7563431"/>
            <a:ext cx="5854306" cy="415921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755934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96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Schematic overview of the phase I study of </a:t>
            </a:r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rizotinib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and PD-0325901 in patients with advanced solid cancer.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Trial design and dose escalation schema.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B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Dose levels and doses per cohort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Representation of treatment schedule.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5C96792-026D-5547-94A1-72AFEC1FA285}"/>
              </a:ext>
            </a:extLst>
          </p:cNvPr>
          <p:cNvSpPr txBox="1"/>
          <p:nvPr/>
        </p:nvSpPr>
        <p:spPr>
          <a:xfrm>
            <a:off x="132235" y="5630741"/>
            <a:ext cx="3712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5C96792-026D-5547-94A1-72AFEC1FA285}"/>
              </a:ext>
            </a:extLst>
          </p:cNvPr>
          <p:cNvSpPr txBox="1"/>
          <p:nvPr/>
        </p:nvSpPr>
        <p:spPr>
          <a:xfrm>
            <a:off x="125410" y="6721262"/>
            <a:ext cx="3712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</a:p>
        </p:txBody>
      </p:sp>
      <p:sp>
        <p:nvSpPr>
          <p:cNvPr id="3" name="Rectangle: Rounded Corners 2">
            <a:extLst>
              <a:ext uri="{FF2B5EF4-FFF2-40B4-BE49-F238E27FC236}">
                <a16:creationId xmlns:a16="http://schemas.microsoft.com/office/drawing/2014/main" id="{EA895E58-F27E-F063-6A29-39146D1CACE3}"/>
              </a:ext>
            </a:extLst>
          </p:cNvPr>
          <p:cNvSpPr/>
          <p:nvPr/>
        </p:nvSpPr>
        <p:spPr>
          <a:xfrm>
            <a:off x="1156875" y="296400"/>
            <a:ext cx="1704441" cy="517502"/>
          </a:xfrm>
          <a:prstGeom prst="round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9D1A5F5-509C-6B81-78C9-5EE163D95E1F}"/>
              </a:ext>
            </a:extLst>
          </p:cNvPr>
          <p:cNvSpPr txBox="1"/>
          <p:nvPr/>
        </p:nvSpPr>
        <p:spPr>
          <a:xfrm>
            <a:off x="1282314" y="263351"/>
            <a:ext cx="146867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DOSE LEVEL 4</a:t>
            </a:r>
          </a:p>
          <a:p>
            <a:pPr algn="ctr"/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crizotinib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PO): 200mg B.D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D-0325901 (PO): 8mg B.D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 = rolling 6</a:t>
            </a:r>
          </a:p>
        </p:txBody>
      </p:sp>
      <p:sp>
        <p:nvSpPr>
          <p:cNvPr id="5" name="Arrow: Down 4">
            <a:extLst>
              <a:ext uri="{FF2B5EF4-FFF2-40B4-BE49-F238E27FC236}">
                <a16:creationId xmlns:a16="http://schemas.microsoft.com/office/drawing/2014/main" id="{4E552375-EDF3-8877-40D7-4C45751ECD6F}"/>
              </a:ext>
            </a:extLst>
          </p:cNvPr>
          <p:cNvSpPr/>
          <p:nvPr/>
        </p:nvSpPr>
        <p:spPr>
          <a:xfrm flipV="1">
            <a:off x="1942535" y="813902"/>
            <a:ext cx="142296" cy="216000"/>
          </a:xfrm>
          <a:prstGeom prst="downArrow">
            <a:avLst/>
          </a:prstGeom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F607384D-D3E8-E516-9662-0E8E15899AD3}"/>
              </a:ext>
            </a:extLst>
          </p:cNvPr>
          <p:cNvSpPr/>
          <p:nvPr/>
        </p:nvSpPr>
        <p:spPr>
          <a:xfrm>
            <a:off x="1148341" y="1450981"/>
            <a:ext cx="1704441" cy="517502"/>
          </a:xfrm>
          <a:prstGeom prst="round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6F9E4D1-5F1D-3F6D-8BD9-E4F8D7AFEF70}"/>
              </a:ext>
            </a:extLst>
          </p:cNvPr>
          <p:cNvSpPr txBox="1"/>
          <p:nvPr/>
        </p:nvSpPr>
        <p:spPr>
          <a:xfrm>
            <a:off x="1273780" y="1417932"/>
            <a:ext cx="146867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DOSE LEVEL 3</a:t>
            </a:r>
          </a:p>
          <a:p>
            <a:pPr algn="ctr"/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crizotinib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PO): 200mg B.D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D-0325901 (PO): 4mg B.D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 = rolling 6</a:t>
            </a:r>
          </a:p>
        </p:txBody>
      </p:sp>
      <p:sp>
        <p:nvSpPr>
          <p:cNvPr id="15" name="Rectangle: Rounded Corners 14">
            <a:extLst>
              <a:ext uri="{FF2B5EF4-FFF2-40B4-BE49-F238E27FC236}">
                <a16:creationId xmlns:a16="http://schemas.microsoft.com/office/drawing/2014/main" id="{508DBAD3-6F62-57CE-9BD7-5AECC90AA171}"/>
              </a:ext>
            </a:extLst>
          </p:cNvPr>
          <p:cNvSpPr/>
          <p:nvPr/>
        </p:nvSpPr>
        <p:spPr>
          <a:xfrm>
            <a:off x="1155658" y="1034013"/>
            <a:ext cx="1704441" cy="192260"/>
          </a:xfrm>
          <a:prstGeom prst="round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8F95FF5-149B-FBA8-760F-A41DADB85E65}"/>
              </a:ext>
            </a:extLst>
          </p:cNvPr>
          <p:cNvSpPr txBox="1"/>
          <p:nvPr/>
        </p:nvSpPr>
        <p:spPr>
          <a:xfrm>
            <a:off x="1457629" y="1022914"/>
            <a:ext cx="11448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0/3 DLT or ≤1/6 DLT</a:t>
            </a:r>
          </a:p>
        </p:txBody>
      </p:sp>
      <p:sp>
        <p:nvSpPr>
          <p:cNvPr id="17" name="Arrow: Down 16">
            <a:extLst>
              <a:ext uri="{FF2B5EF4-FFF2-40B4-BE49-F238E27FC236}">
                <a16:creationId xmlns:a16="http://schemas.microsoft.com/office/drawing/2014/main" id="{BB65FEEC-6EC3-A789-207E-82CCCF14E901}"/>
              </a:ext>
            </a:extLst>
          </p:cNvPr>
          <p:cNvSpPr/>
          <p:nvPr/>
        </p:nvSpPr>
        <p:spPr>
          <a:xfrm flipV="1">
            <a:off x="1948633" y="1229651"/>
            <a:ext cx="142296" cy="216000"/>
          </a:xfrm>
          <a:prstGeom prst="downArrow">
            <a:avLst/>
          </a:prstGeom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8" name="Arrow: Down 17">
            <a:extLst>
              <a:ext uri="{FF2B5EF4-FFF2-40B4-BE49-F238E27FC236}">
                <a16:creationId xmlns:a16="http://schemas.microsoft.com/office/drawing/2014/main" id="{5235D790-3827-919E-DA12-9D77CABDBA5F}"/>
              </a:ext>
            </a:extLst>
          </p:cNvPr>
          <p:cNvSpPr/>
          <p:nvPr/>
        </p:nvSpPr>
        <p:spPr>
          <a:xfrm rot="5400000" flipV="1">
            <a:off x="2891076" y="1616137"/>
            <a:ext cx="142296" cy="216000"/>
          </a:xfrm>
          <a:prstGeom prst="downArrow">
            <a:avLst/>
          </a:prstGeom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Rectangle: Rounded Corners 18">
            <a:extLst>
              <a:ext uri="{FF2B5EF4-FFF2-40B4-BE49-F238E27FC236}">
                <a16:creationId xmlns:a16="http://schemas.microsoft.com/office/drawing/2014/main" id="{7FF1DEA2-4A45-0BE7-6983-F323E66BA5C3}"/>
              </a:ext>
            </a:extLst>
          </p:cNvPr>
          <p:cNvSpPr/>
          <p:nvPr/>
        </p:nvSpPr>
        <p:spPr>
          <a:xfrm>
            <a:off x="3065071" y="1552173"/>
            <a:ext cx="943468" cy="343159"/>
          </a:xfrm>
          <a:prstGeom prst="round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23C86BF-2261-71AB-229E-F81DD40AC3DF}"/>
              </a:ext>
            </a:extLst>
          </p:cNvPr>
          <p:cNvSpPr txBox="1"/>
          <p:nvPr/>
        </p:nvSpPr>
        <p:spPr>
          <a:xfrm>
            <a:off x="2939542" y="1541075"/>
            <a:ext cx="11569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If dose level 3 defined as MTD</a:t>
            </a:r>
          </a:p>
        </p:txBody>
      </p:sp>
      <p:sp>
        <p:nvSpPr>
          <p:cNvPr id="21" name="Rectangle: Rounded Corners 20">
            <a:extLst>
              <a:ext uri="{FF2B5EF4-FFF2-40B4-BE49-F238E27FC236}">
                <a16:creationId xmlns:a16="http://schemas.microsoft.com/office/drawing/2014/main" id="{BAD086A4-A726-83AE-BE62-ECCEE1949EDD}"/>
              </a:ext>
            </a:extLst>
          </p:cNvPr>
          <p:cNvSpPr/>
          <p:nvPr/>
        </p:nvSpPr>
        <p:spPr>
          <a:xfrm>
            <a:off x="4248765" y="1449763"/>
            <a:ext cx="1704441" cy="517502"/>
          </a:xfrm>
          <a:prstGeom prst="round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6EB3F51-7371-E0C8-0446-0A077756FC8E}"/>
              </a:ext>
            </a:extLst>
          </p:cNvPr>
          <p:cNvSpPr txBox="1"/>
          <p:nvPr/>
        </p:nvSpPr>
        <p:spPr>
          <a:xfrm>
            <a:off x="4374204" y="1416714"/>
            <a:ext cx="146867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DOSE LEVEL 3a</a:t>
            </a:r>
          </a:p>
          <a:p>
            <a:pPr algn="ctr"/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crizotinib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PO): 250mg O.D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D-0325901 (PO): 8mg B.D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 = rolling 6</a:t>
            </a:r>
          </a:p>
        </p:txBody>
      </p:sp>
      <p:sp>
        <p:nvSpPr>
          <p:cNvPr id="23" name="Arrow: Down 22">
            <a:extLst>
              <a:ext uri="{FF2B5EF4-FFF2-40B4-BE49-F238E27FC236}">
                <a16:creationId xmlns:a16="http://schemas.microsoft.com/office/drawing/2014/main" id="{68BB209F-E43F-9321-6E9B-97FEA8A616B1}"/>
              </a:ext>
            </a:extLst>
          </p:cNvPr>
          <p:cNvSpPr/>
          <p:nvPr/>
        </p:nvSpPr>
        <p:spPr>
          <a:xfrm rot="5400000" flipV="1">
            <a:off x="4052969" y="1607604"/>
            <a:ext cx="142296" cy="216000"/>
          </a:xfrm>
          <a:prstGeom prst="downArrow">
            <a:avLst/>
          </a:prstGeom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4" name="Arrow: Down 23">
            <a:extLst>
              <a:ext uri="{FF2B5EF4-FFF2-40B4-BE49-F238E27FC236}">
                <a16:creationId xmlns:a16="http://schemas.microsoft.com/office/drawing/2014/main" id="{3FCDF0FF-2B51-631F-3F00-220D8BBD1F8A}"/>
              </a:ext>
            </a:extLst>
          </p:cNvPr>
          <p:cNvSpPr/>
          <p:nvPr/>
        </p:nvSpPr>
        <p:spPr>
          <a:xfrm flipV="1">
            <a:off x="1934001" y="1975796"/>
            <a:ext cx="142296" cy="216000"/>
          </a:xfrm>
          <a:prstGeom prst="downArrow">
            <a:avLst/>
          </a:prstGeom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5" name="Rectangle: Rounded Corners 24">
            <a:extLst>
              <a:ext uri="{FF2B5EF4-FFF2-40B4-BE49-F238E27FC236}">
                <a16:creationId xmlns:a16="http://schemas.microsoft.com/office/drawing/2014/main" id="{BBA13B31-21CB-14C7-7909-4C092D93F68C}"/>
              </a:ext>
            </a:extLst>
          </p:cNvPr>
          <p:cNvSpPr/>
          <p:nvPr/>
        </p:nvSpPr>
        <p:spPr>
          <a:xfrm>
            <a:off x="1139807" y="2612875"/>
            <a:ext cx="1704441" cy="517502"/>
          </a:xfrm>
          <a:prstGeom prst="round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F45A593-3A3D-8207-E4B8-56060AB88AA8}"/>
              </a:ext>
            </a:extLst>
          </p:cNvPr>
          <p:cNvSpPr txBox="1"/>
          <p:nvPr/>
        </p:nvSpPr>
        <p:spPr>
          <a:xfrm>
            <a:off x="1265246" y="2579826"/>
            <a:ext cx="146867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DOSE LEVEL 2</a:t>
            </a:r>
          </a:p>
          <a:p>
            <a:pPr algn="ctr"/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crizotinib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PO): 200mg B.D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D-0325901 (PO): 2mg B.D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 = rolling 6</a:t>
            </a:r>
          </a:p>
        </p:txBody>
      </p:sp>
      <p:sp>
        <p:nvSpPr>
          <p:cNvPr id="27" name="Rectangle: Rounded Corners 26">
            <a:extLst>
              <a:ext uri="{FF2B5EF4-FFF2-40B4-BE49-F238E27FC236}">
                <a16:creationId xmlns:a16="http://schemas.microsoft.com/office/drawing/2014/main" id="{E154EC6C-0377-5272-4B03-701098AB0A83}"/>
              </a:ext>
            </a:extLst>
          </p:cNvPr>
          <p:cNvSpPr/>
          <p:nvPr/>
        </p:nvSpPr>
        <p:spPr>
          <a:xfrm>
            <a:off x="1147124" y="2195907"/>
            <a:ext cx="1704441" cy="192260"/>
          </a:xfrm>
          <a:prstGeom prst="round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4501A1C-FD62-A0AF-1D1F-1444FF4FB188}"/>
              </a:ext>
            </a:extLst>
          </p:cNvPr>
          <p:cNvSpPr txBox="1"/>
          <p:nvPr/>
        </p:nvSpPr>
        <p:spPr>
          <a:xfrm>
            <a:off x="1449095" y="2184808"/>
            <a:ext cx="11448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0/3 DLT or ≤1/6 DLT</a:t>
            </a:r>
          </a:p>
        </p:txBody>
      </p:sp>
      <p:sp>
        <p:nvSpPr>
          <p:cNvPr id="29" name="Arrow: Down 28">
            <a:extLst>
              <a:ext uri="{FF2B5EF4-FFF2-40B4-BE49-F238E27FC236}">
                <a16:creationId xmlns:a16="http://schemas.microsoft.com/office/drawing/2014/main" id="{A0447A27-7631-9D88-B9D3-F9064494A1B6}"/>
              </a:ext>
            </a:extLst>
          </p:cNvPr>
          <p:cNvSpPr/>
          <p:nvPr/>
        </p:nvSpPr>
        <p:spPr>
          <a:xfrm flipV="1">
            <a:off x="1940099" y="2391545"/>
            <a:ext cx="142296" cy="216000"/>
          </a:xfrm>
          <a:prstGeom prst="downArrow">
            <a:avLst/>
          </a:prstGeom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0" name="Arrow: Down 29">
            <a:extLst>
              <a:ext uri="{FF2B5EF4-FFF2-40B4-BE49-F238E27FC236}">
                <a16:creationId xmlns:a16="http://schemas.microsoft.com/office/drawing/2014/main" id="{5C354BC7-02AC-72BA-E36E-BCCF940294D2}"/>
              </a:ext>
            </a:extLst>
          </p:cNvPr>
          <p:cNvSpPr/>
          <p:nvPr/>
        </p:nvSpPr>
        <p:spPr>
          <a:xfrm rot="5400000" flipV="1">
            <a:off x="2882542" y="2778031"/>
            <a:ext cx="142296" cy="216000"/>
          </a:xfrm>
          <a:prstGeom prst="downArrow">
            <a:avLst/>
          </a:prstGeom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1" name="Rectangle: Rounded Corners 30">
            <a:extLst>
              <a:ext uri="{FF2B5EF4-FFF2-40B4-BE49-F238E27FC236}">
                <a16:creationId xmlns:a16="http://schemas.microsoft.com/office/drawing/2014/main" id="{71198EB5-1FF8-E3F5-99E6-2051FCD0A9A2}"/>
              </a:ext>
            </a:extLst>
          </p:cNvPr>
          <p:cNvSpPr/>
          <p:nvPr/>
        </p:nvSpPr>
        <p:spPr>
          <a:xfrm>
            <a:off x="3056537" y="2714067"/>
            <a:ext cx="943468" cy="343159"/>
          </a:xfrm>
          <a:prstGeom prst="round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F1096CC-AC91-1727-8C37-9F0EDFF63D4B}"/>
              </a:ext>
            </a:extLst>
          </p:cNvPr>
          <p:cNvSpPr txBox="1"/>
          <p:nvPr/>
        </p:nvSpPr>
        <p:spPr>
          <a:xfrm>
            <a:off x="2931008" y="2702969"/>
            <a:ext cx="11569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If dose level 2 defined as MTD</a:t>
            </a:r>
          </a:p>
        </p:txBody>
      </p:sp>
      <p:sp>
        <p:nvSpPr>
          <p:cNvPr id="33" name="Rectangle: Rounded Corners 32">
            <a:extLst>
              <a:ext uri="{FF2B5EF4-FFF2-40B4-BE49-F238E27FC236}">
                <a16:creationId xmlns:a16="http://schemas.microsoft.com/office/drawing/2014/main" id="{110E597B-237D-8A41-0B9C-8F750A4F2398}"/>
              </a:ext>
            </a:extLst>
          </p:cNvPr>
          <p:cNvSpPr/>
          <p:nvPr/>
        </p:nvSpPr>
        <p:spPr>
          <a:xfrm>
            <a:off x="4240231" y="2611657"/>
            <a:ext cx="1704441" cy="517502"/>
          </a:xfrm>
          <a:prstGeom prst="round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D5C1981-15B8-E6AE-1668-15E160562B03}"/>
              </a:ext>
            </a:extLst>
          </p:cNvPr>
          <p:cNvSpPr txBox="1"/>
          <p:nvPr/>
        </p:nvSpPr>
        <p:spPr>
          <a:xfrm>
            <a:off x="4365670" y="2578608"/>
            <a:ext cx="146867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DOSE LEVEL 2a</a:t>
            </a:r>
          </a:p>
          <a:p>
            <a:pPr algn="ctr"/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crizotinib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PO): 250mg O.D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D-0325901 (PO): 4mg B.D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 = rolling 6</a:t>
            </a:r>
          </a:p>
        </p:txBody>
      </p:sp>
      <p:sp>
        <p:nvSpPr>
          <p:cNvPr id="35" name="Arrow: Down 34">
            <a:extLst>
              <a:ext uri="{FF2B5EF4-FFF2-40B4-BE49-F238E27FC236}">
                <a16:creationId xmlns:a16="http://schemas.microsoft.com/office/drawing/2014/main" id="{9D1C8750-3082-6021-11DD-ABACCA00C7FD}"/>
              </a:ext>
            </a:extLst>
          </p:cNvPr>
          <p:cNvSpPr/>
          <p:nvPr/>
        </p:nvSpPr>
        <p:spPr>
          <a:xfrm rot="5400000" flipV="1">
            <a:off x="4044435" y="2769498"/>
            <a:ext cx="142296" cy="216000"/>
          </a:xfrm>
          <a:prstGeom prst="downArrow">
            <a:avLst/>
          </a:prstGeom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6" name="Arrow: Down 35">
            <a:extLst>
              <a:ext uri="{FF2B5EF4-FFF2-40B4-BE49-F238E27FC236}">
                <a16:creationId xmlns:a16="http://schemas.microsoft.com/office/drawing/2014/main" id="{8E2CBEAF-A060-1802-94D4-4C7BB9EE3B52}"/>
              </a:ext>
            </a:extLst>
          </p:cNvPr>
          <p:cNvSpPr/>
          <p:nvPr/>
        </p:nvSpPr>
        <p:spPr>
          <a:xfrm flipV="1">
            <a:off x="1932783" y="3137693"/>
            <a:ext cx="142296" cy="216000"/>
          </a:xfrm>
          <a:prstGeom prst="downArrow">
            <a:avLst/>
          </a:prstGeom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7" name="Rectangle: Rounded Corners 36">
            <a:extLst>
              <a:ext uri="{FF2B5EF4-FFF2-40B4-BE49-F238E27FC236}">
                <a16:creationId xmlns:a16="http://schemas.microsoft.com/office/drawing/2014/main" id="{3E70051A-D312-7802-CDDE-B147F2EA9191}"/>
              </a:ext>
            </a:extLst>
          </p:cNvPr>
          <p:cNvSpPr/>
          <p:nvPr/>
        </p:nvSpPr>
        <p:spPr>
          <a:xfrm>
            <a:off x="1138589" y="3774772"/>
            <a:ext cx="1704441" cy="517502"/>
          </a:xfrm>
          <a:prstGeom prst="round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2123C4A-CDDF-3547-C674-8F5F340B60A6}"/>
              </a:ext>
            </a:extLst>
          </p:cNvPr>
          <p:cNvSpPr txBox="1"/>
          <p:nvPr/>
        </p:nvSpPr>
        <p:spPr>
          <a:xfrm>
            <a:off x="1264027" y="3741723"/>
            <a:ext cx="146867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DOSE LEVEL 1</a:t>
            </a:r>
          </a:p>
          <a:p>
            <a:pPr algn="ctr"/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crizotinib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PO): 250mg O.D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D-0325901 (PO): 2mg B.D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 = rolling 6</a:t>
            </a:r>
          </a:p>
        </p:txBody>
      </p:sp>
      <p:sp>
        <p:nvSpPr>
          <p:cNvPr id="39" name="Rectangle: Rounded Corners 38">
            <a:extLst>
              <a:ext uri="{FF2B5EF4-FFF2-40B4-BE49-F238E27FC236}">
                <a16:creationId xmlns:a16="http://schemas.microsoft.com/office/drawing/2014/main" id="{6182196F-1FEF-63C9-5551-FA50DA42BA54}"/>
              </a:ext>
            </a:extLst>
          </p:cNvPr>
          <p:cNvSpPr/>
          <p:nvPr/>
        </p:nvSpPr>
        <p:spPr>
          <a:xfrm>
            <a:off x="1145906" y="3357804"/>
            <a:ext cx="1704441" cy="192260"/>
          </a:xfrm>
          <a:prstGeom prst="round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925F5CC-377D-E258-874B-F60EAC51833C}"/>
              </a:ext>
            </a:extLst>
          </p:cNvPr>
          <p:cNvSpPr txBox="1"/>
          <p:nvPr/>
        </p:nvSpPr>
        <p:spPr>
          <a:xfrm>
            <a:off x="1447877" y="3346705"/>
            <a:ext cx="11448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0/3 DLT or ≤1/6 DLT</a:t>
            </a:r>
          </a:p>
        </p:txBody>
      </p:sp>
      <p:sp>
        <p:nvSpPr>
          <p:cNvPr id="41" name="Arrow: Down 40">
            <a:extLst>
              <a:ext uri="{FF2B5EF4-FFF2-40B4-BE49-F238E27FC236}">
                <a16:creationId xmlns:a16="http://schemas.microsoft.com/office/drawing/2014/main" id="{051666B2-799F-39B7-4F3E-1E647C6C96D0}"/>
              </a:ext>
            </a:extLst>
          </p:cNvPr>
          <p:cNvSpPr/>
          <p:nvPr/>
        </p:nvSpPr>
        <p:spPr>
          <a:xfrm flipV="1">
            <a:off x="1938881" y="3553442"/>
            <a:ext cx="142296" cy="216000"/>
          </a:xfrm>
          <a:prstGeom prst="downArrow">
            <a:avLst/>
          </a:prstGeom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5" name="Arrow: Down 44">
            <a:extLst>
              <a:ext uri="{FF2B5EF4-FFF2-40B4-BE49-F238E27FC236}">
                <a16:creationId xmlns:a16="http://schemas.microsoft.com/office/drawing/2014/main" id="{D4CD98ED-F0F3-B9AB-3992-C9FB4C005D8B}"/>
              </a:ext>
            </a:extLst>
          </p:cNvPr>
          <p:cNvSpPr/>
          <p:nvPr/>
        </p:nvSpPr>
        <p:spPr>
          <a:xfrm>
            <a:off x="1938880" y="4292271"/>
            <a:ext cx="142296" cy="216000"/>
          </a:xfrm>
          <a:prstGeom prst="downArrow">
            <a:avLst/>
          </a:prstGeom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6" name="Rectangle: Rounded Corners 45">
            <a:extLst>
              <a:ext uri="{FF2B5EF4-FFF2-40B4-BE49-F238E27FC236}">
                <a16:creationId xmlns:a16="http://schemas.microsoft.com/office/drawing/2014/main" id="{6EEA6DCA-B2CE-F444-78CE-60C549E1E21E}"/>
              </a:ext>
            </a:extLst>
          </p:cNvPr>
          <p:cNvSpPr/>
          <p:nvPr/>
        </p:nvSpPr>
        <p:spPr>
          <a:xfrm>
            <a:off x="1144686" y="4929350"/>
            <a:ext cx="1704441" cy="674838"/>
          </a:xfrm>
          <a:prstGeom prst="round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9832E6C5-7F11-87F7-24D0-854C23D340D7}"/>
              </a:ext>
            </a:extLst>
          </p:cNvPr>
          <p:cNvSpPr txBox="1"/>
          <p:nvPr/>
        </p:nvSpPr>
        <p:spPr>
          <a:xfrm>
            <a:off x="1155657" y="4896301"/>
            <a:ext cx="170565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Change either: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D-0325901 to other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MEKi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e.g.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Binimetinib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, Trametinib or Selumetinib)</a:t>
            </a:r>
          </a:p>
          <a:p>
            <a:pPr algn="ctr"/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crizotinib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to MET monoclonal Ab </a:t>
            </a:r>
          </a:p>
        </p:txBody>
      </p:sp>
      <p:sp>
        <p:nvSpPr>
          <p:cNvPr id="48" name="Rectangle: Rounded Corners 47">
            <a:extLst>
              <a:ext uri="{FF2B5EF4-FFF2-40B4-BE49-F238E27FC236}">
                <a16:creationId xmlns:a16="http://schemas.microsoft.com/office/drawing/2014/main" id="{67263CE0-1E10-B8EF-5959-8A76AC974FD3}"/>
              </a:ext>
            </a:extLst>
          </p:cNvPr>
          <p:cNvSpPr/>
          <p:nvPr/>
        </p:nvSpPr>
        <p:spPr>
          <a:xfrm>
            <a:off x="1152003" y="4512382"/>
            <a:ext cx="1704441" cy="192260"/>
          </a:xfrm>
          <a:prstGeom prst="round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8B2DD9B-1B0D-F3DA-C459-BF579DAB0F91}"/>
              </a:ext>
            </a:extLst>
          </p:cNvPr>
          <p:cNvSpPr txBox="1"/>
          <p:nvPr/>
        </p:nvSpPr>
        <p:spPr>
          <a:xfrm>
            <a:off x="1436342" y="4501283"/>
            <a:ext cx="11801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≥2/3 DLT or ≥2/6 DLT</a:t>
            </a:r>
          </a:p>
        </p:txBody>
      </p:sp>
      <p:sp>
        <p:nvSpPr>
          <p:cNvPr id="50" name="Arrow: Down 49">
            <a:extLst>
              <a:ext uri="{FF2B5EF4-FFF2-40B4-BE49-F238E27FC236}">
                <a16:creationId xmlns:a16="http://schemas.microsoft.com/office/drawing/2014/main" id="{D88B31BC-3E22-7345-32FA-57EF5F06D2F4}"/>
              </a:ext>
            </a:extLst>
          </p:cNvPr>
          <p:cNvSpPr/>
          <p:nvPr/>
        </p:nvSpPr>
        <p:spPr>
          <a:xfrm>
            <a:off x="1944978" y="4708020"/>
            <a:ext cx="142296" cy="216000"/>
          </a:xfrm>
          <a:prstGeom prst="downArrow">
            <a:avLst/>
          </a:prstGeom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4496825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61730906"/>
              </p:ext>
            </p:extLst>
          </p:nvPr>
        </p:nvGraphicFramePr>
        <p:xfrm>
          <a:off x="387988" y="107104"/>
          <a:ext cx="3237086" cy="18687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866514" imgH="2810528" progId="Prism8.Document">
                  <p:embed/>
                </p:oleObj>
              </mc:Choice>
              <mc:Fallback>
                <p:oleObj name="Prism 8" r:id="rId2" imgW="4866514" imgH="2810528" progId="Prism8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87988" y="107104"/>
                        <a:ext cx="3237086" cy="18687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A5C96792-026D-5547-94A1-72AFEC1FA285}"/>
              </a:ext>
            </a:extLst>
          </p:cNvPr>
          <p:cNvSpPr txBox="1"/>
          <p:nvPr/>
        </p:nvSpPr>
        <p:spPr>
          <a:xfrm>
            <a:off x="126794" y="157901"/>
            <a:ext cx="3712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5C96792-026D-5547-94A1-72AFEC1FA285}"/>
              </a:ext>
            </a:extLst>
          </p:cNvPr>
          <p:cNvSpPr txBox="1"/>
          <p:nvPr/>
        </p:nvSpPr>
        <p:spPr>
          <a:xfrm>
            <a:off x="124552" y="2017611"/>
            <a:ext cx="3712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</a:p>
        </p:txBody>
      </p:sp>
      <p:sp>
        <p:nvSpPr>
          <p:cNvPr id="9" name="Title 5">
            <a:extLst>
              <a:ext uri="{FF2B5EF4-FFF2-40B4-BE49-F238E27FC236}">
                <a16:creationId xmlns:a16="http://schemas.microsoft.com/office/drawing/2014/main" id="{A1E26514-425F-884D-A2B4-4F2E2E493AF4}"/>
              </a:ext>
            </a:extLst>
          </p:cNvPr>
          <p:cNvSpPr txBox="1">
            <a:spLocks/>
          </p:cNvSpPr>
          <p:nvPr/>
        </p:nvSpPr>
        <p:spPr>
          <a:xfrm>
            <a:off x="-1" y="7991901"/>
            <a:ext cx="7559675" cy="109676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755934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96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Effect of increasing doses of PD-0325901 on pharmacokinetic parameters for PD-0325901 and its metabolite PD-0315209. A. Left: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Relationship between B.D. dose of PD-0325901 and AUC</a:t>
            </a:r>
            <a:r>
              <a:rPr lang="en-GB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0-10h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for PD-0325901 and PD-0315209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Right: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Linearity of the effect of B.D. dose of PD-0325901 on AUC</a:t>
            </a:r>
            <a:r>
              <a:rPr lang="en-GB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0-10h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for PD-0325901 and PD-0315209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B. Left: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Relationship between B.D. dose of PD-0325901 and C</a:t>
            </a:r>
            <a:r>
              <a:rPr lang="en-GB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MAX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for PD-0325901 and PD-0315209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Right: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Linearity of the effect of B.D. dose of PD-0325901 on C</a:t>
            </a:r>
            <a:r>
              <a:rPr lang="en-GB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MAX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for PD-0325901 and PD-0315209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C. Left: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Relationship between B.D. dose of PD-0325901 and C</a:t>
            </a:r>
            <a:r>
              <a:rPr lang="en-GB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for PD-0325901 and PD-0315209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Right: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Linearity of the effect of B.D. dose of PD-0325901 on C</a:t>
            </a:r>
            <a:r>
              <a:rPr lang="en-GB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for PD-0325901 and PD-0315209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Relationship between dose and pre-dose concentration of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: PD-0325901 and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: its metabolite PD-0315209 in cohorts 1- 4. 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Tab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71696887"/>
              </p:ext>
            </p:extLst>
          </p:nvPr>
        </p:nvGraphicFramePr>
        <p:xfrm>
          <a:off x="3773508" y="431441"/>
          <a:ext cx="3422660" cy="1005840"/>
        </p:xfrm>
        <a:graphic>
          <a:graphicData uri="http://schemas.openxmlformats.org/drawingml/2006/table">
            <a:tbl>
              <a:tblPr firstRow="1" bandRow="1">
                <a:tableStyleId>{EB344D84-9AFB-497E-A393-DC336BA19D2E}</a:tableStyleId>
              </a:tblPr>
              <a:tblGrid>
                <a:gridCol w="684532">
                  <a:extLst>
                    <a:ext uri="{9D8B030D-6E8A-4147-A177-3AD203B41FA5}">
                      <a16:colId xmlns:a16="http://schemas.microsoft.com/office/drawing/2014/main" val="3437028434"/>
                    </a:ext>
                  </a:extLst>
                </a:gridCol>
                <a:gridCol w="684532">
                  <a:extLst>
                    <a:ext uri="{9D8B030D-6E8A-4147-A177-3AD203B41FA5}">
                      <a16:colId xmlns:a16="http://schemas.microsoft.com/office/drawing/2014/main" val="1305443840"/>
                    </a:ext>
                  </a:extLst>
                </a:gridCol>
                <a:gridCol w="684532">
                  <a:extLst>
                    <a:ext uri="{9D8B030D-6E8A-4147-A177-3AD203B41FA5}">
                      <a16:colId xmlns:a16="http://schemas.microsoft.com/office/drawing/2014/main" val="1896836528"/>
                    </a:ext>
                  </a:extLst>
                </a:gridCol>
                <a:gridCol w="684532">
                  <a:extLst>
                    <a:ext uri="{9D8B030D-6E8A-4147-A177-3AD203B41FA5}">
                      <a16:colId xmlns:a16="http://schemas.microsoft.com/office/drawing/2014/main" val="3721882981"/>
                    </a:ext>
                  </a:extLst>
                </a:gridCol>
                <a:gridCol w="684532">
                  <a:extLst>
                    <a:ext uri="{9D8B030D-6E8A-4147-A177-3AD203B41FA5}">
                      <a16:colId xmlns:a16="http://schemas.microsoft.com/office/drawing/2014/main" val="3834456795"/>
                    </a:ext>
                  </a:extLst>
                </a:gridCol>
              </a:tblGrid>
              <a:tr h="161906">
                <a:tc>
                  <a:txBody>
                    <a:bodyPr/>
                    <a:lstStyle/>
                    <a:p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-0325901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-0315209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41204411"/>
                  </a:ext>
                </a:extLst>
              </a:tr>
              <a:tr h="222621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cle/Da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ear regressio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GB" sz="8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ear regressio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GB" sz="8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597277900"/>
                  </a:ext>
                </a:extLst>
              </a:tr>
              <a:tr h="161906"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D-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1 </a:t>
                      </a:r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 8.7</a:t>
                      </a:r>
                      <a:endParaRPr lang="en-GB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1 </a:t>
                      </a:r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 17</a:t>
                      </a:r>
                      <a:endParaRPr lang="en-GB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593325333"/>
                  </a:ext>
                </a:extLst>
              </a:tr>
              <a:tr h="161906"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D2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9 </a:t>
                      </a:r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 7.2</a:t>
                      </a:r>
                      <a:endParaRPr lang="en-GB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1 </a:t>
                      </a:r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 15</a:t>
                      </a:r>
                      <a:endParaRPr lang="en-GB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020683045"/>
                  </a:ext>
                </a:extLst>
              </a:tr>
            </a:tbl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99822025"/>
              </p:ext>
            </p:extLst>
          </p:nvPr>
        </p:nvGraphicFramePr>
        <p:xfrm>
          <a:off x="440094" y="2133712"/>
          <a:ext cx="3179762" cy="1868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4781162" imgH="2810528" progId="Prism8.Document">
                  <p:embed/>
                </p:oleObj>
              </mc:Choice>
              <mc:Fallback>
                <p:oleObj name="Prism 8" r:id="rId4" imgW="4781162" imgH="2810528" progId="Prism8.Document">
                  <p:embed/>
                  <p:pic>
                    <p:nvPicPr>
                      <p:cNvPr id="11" name="Object 10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40094" y="2133712"/>
                        <a:ext cx="3179762" cy="18684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Table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25648787"/>
              </p:ext>
            </p:extLst>
          </p:nvPr>
        </p:nvGraphicFramePr>
        <p:xfrm>
          <a:off x="3771364" y="2496345"/>
          <a:ext cx="3422660" cy="1005840"/>
        </p:xfrm>
        <a:graphic>
          <a:graphicData uri="http://schemas.openxmlformats.org/drawingml/2006/table">
            <a:tbl>
              <a:tblPr firstRow="1" bandRow="1">
                <a:tableStyleId>{EB344D84-9AFB-497E-A393-DC336BA19D2E}</a:tableStyleId>
              </a:tblPr>
              <a:tblGrid>
                <a:gridCol w="684532">
                  <a:extLst>
                    <a:ext uri="{9D8B030D-6E8A-4147-A177-3AD203B41FA5}">
                      <a16:colId xmlns:a16="http://schemas.microsoft.com/office/drawing/2014/main" val="3437028434"/>
                    </a:ext>
                  </a:extLst>
                </a:gridCol>
                <a:gridCol w="684532">
                  <a:extLst>
                    <a:ext uri="{9D8B030D-6E8A-4147-A177-3AD203B41FA5}">
                      <a16:colId xmlns:a16="http://schemas.microsoft.com/office/drawing/2014/main" val="1305443840"/>
                    </a:ext>
                  </a:extLst>
                </a:gridCol>
                <a:gridCol w="684532">
                  <a:extLst>
                    <a:ext uri="{9D8B030D-6E8A-4147-A177-3AD203B41FA5}">
                      <a16:colId xmlns:a16="http://schemas.microsoft.com/office/drawing/2014/main" val="1896836528"/>
                    </a:ext>
                  </a:extLst>
                </a:gridCol>
                <a:gridCol w="684532">
                  <a:extLst>
                    <a:ext uri="{9D8B030D-6E8A-4147-A177-3AD203B41FA5}">
                      <a16:colId xmlns:a16="http://schemas.microsoft.com/office/drawing/2014/main" val="3721882981"/>
                    </a:ext>
                  </a:extLst>
                </a:gridCol>
                <a:gridCol w="684532">
                  <a:extLst>
                    <a:ext uri="{9D8B030D-6E8A-4147-A177-3AD203B41FA5}">
                      <a16:colId xmlns:a16="http://schemas.microsoft.com/office/drawing/2014/main" val="3834456795"/>
                    </a:ext>
                  </a:extLst>
                </a:gridCol>
              </a:tblGrid>
              <a:tr h="161906">
                <a:tc>
                  <a:txBody>
                    <a:bodyPr/>
                    <a:lstStyle/>
                    <a:p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-0325901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-0315209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41204411"/>
                  </a:ext>
                </a:extLst>
              </a:tr>
              <a:tr h="222621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cle/Da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ear regressio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GB" sz="8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ear regressio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GB" sz="8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597277900"/>
                  </a:ext>
                </a:extLst>
              </a:tr>
              <a:tr h="161906"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D-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60.0  3.0</a:t>
                      </a:r>
                      <a:endParaRPr lang="en-GB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.3 </a:t>
                      </a:r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 2.0</a:t>
                      </a:r>
                      <a:endParaRPr lang="en-GB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593325333"/>
                  </a:ext>
                </a:extLst>
              </a:tr>
              <a:tr h="161906"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D2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5 </a:t>
                      </a:r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  3.2</a:t>
                      </a:r>
                      <a:endParaRPr lang="en-GB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8 </a:t>
                      </a:r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 2.5</a:t>
                      </a:r>
                      <a:endParaRPr lang="en-GB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020683045"/>
                  </a:ext>
                </a:extLst>
              </a:tr>
            </a:tbl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A5C96792-026D-5547-94A1-72AFEC1FA285}"/>
              </a:ext>
            </a:extLst>
          </p:cNvPr>
          <p:cNvSpPr txBox="1"/>
          <p:nvPr/>
        </p:nvSpPr>
        <p:spPr>
          <a:xfrm>
            <a:off x="128097" y="3950966"/>
            <a:ext cx="3712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</a:p>
        </p:txBody>
      </p:sp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5834187"/>
              </p:ext>
            </p:extLst>
          </p:nvPr>
        </p:nvGraphicFramePr>
        <p:xfrm>
          <a:off x="441325" y="4067175"/>
          <a:ext cx="3182938" cy="18684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4784043" imgH="2810528" progId="Prism8.Document">
                  <p:embed/>
                </p:oleObj>
              </mc:Choice>
              <mc:Fallback>
                <p:oleObj name="Prism 8" r:id="rId6" imgW="4784043" imgH="2810528" progId="Prism8.Document">
                  <p:embed/>
                  <p:pic>
                    <p:nvPicPr>
                      <p:cNvPr id="15" name="Object 14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41325" y="4067175"/>
                        <a:ext cx="3182938" cy="18684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Table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01802007"/>
              </p:ext>
            </p:extLst>
          </p:nvPr>
        </p:nvGraphicFramePr>
        <p:xfrm>
          <a:off x="3769591" y="4408438"/>
          <a:ext cx="3422660" cy="1005840"/>
        </p:xfrm>
        <a:graphic>
          <a:graphicData uri="http://schemas.openxmlformats.org/drawingml/2006/table">
            <a:tbl>
              <a:tblPr firstRow="1" bandRow="1">
                <a:tableStyleId>{EB344D84-9AFB-497E-A393-DC336BA19D2E}</a:tableStyleId>
              </a:tblPr>
              <a:tblGrid>
                <a:gridCol w="684532">
                  <a:extLst>
                    <a:ext uri="{9D8B030D-6E8A-4147-A177-3AD203B41FA5}">
                      <a16:colId xmlns:a16="http://schemas.microsoft.com/office/drawing/2014/main" val="3437028434"/>
                    </a:ext>
                  </a:extLst>
                </a:gridCol>
                <a:gridCol w="684532">
                  <a:extLst>
                    <a:ext uri="{9D8B030D-6E8A-4147-A177-3AD203B41FA5}">
                      <a16:colId xmlns:a16="http://schemas.microsoft.com/office/drawing/2014/main" val="1305443840"/>
                    </a:ext>
                  </a:extLst>
                </a:gridCol>
                <a:gridCol w="684532">
                  <a:extLst>
                    <a:ext uri="{9D8B030D-6E8A-4147-A177-3AD203B41FA5}">
                      <a16:colId xmlns:a16="http://schemas.microsoft.com/office/drawing/2014/main" val="1896836528"/>
                    </a:ext>
                  </a:extLst>
                </a:gridCol>
                <a:gridCol w="684532">
                  <a:extLst>
                    <a:ext uri="{9D8B030D-6E8A-4147-A177-3AD203B41FA5}">
                      <a16:colId xmlns:a16="http://schemas.microsoft.com/office/drawing/2014/main" val="3721882981"/>
                    </a:ext>
                  </a:extLst>
                </a:gridCol>
                <a:gridCol w="684532">
                  <a:extLst>
                    <a:ext uri="{9D8B030D-6E8A-4147-A177-3AD203B41FA5}">
                      <a16:colId xmlns:a16="http://schemas.microsoft.com/office/drawing/2014/main" val="3834456795"/>
                    </a:ext>
                  </a:extLst>
                </a:gridCol>
              </a:tblGrid>
              <a:tr h="161906">
                <a:tc>
                  <a:txBody>
                    <a:bodyPr/>
                    <a:lstStyle/>
                    <a:p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-0325901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9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-0315209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41204411"/>
                  </a:ext>
                </a:extLst>
              </a:tr>
              <a:tr h="222621">
                <a:tc>
                  <a:txBody>
                    <a:bodyPr/>
                    <a:lstStyle/>
                    <a:p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cle/Da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ear regressio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GB" sz="8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ear regressio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GB" sz="8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597277900"/>
                  </a:ext>
                </a:extLst>
              </a:tr>
              <a:tr h="161906"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D-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10.8</a:t>
                      </a:r>
                      <a:r>
                        <a:rPr lang="en-GB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 </a:t>
                      </a:r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 0.7</a:t>
                      </a:r>
                      <a:endParaRPr lang="en-GB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7 </a:t>
                      </a:r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 1.5</a:t>
                      </a:r>
                      <a:endParaRPr lang="en-GB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593325333"/>
                  </a:ext>
                </a:extLst>
              </a:tr>
              <a:tr h="161906"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D2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4 </a:t>
                      </a:r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 0.6</a:t>
                      </a:r>
                      <a:endParaRPr lang="en-GB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8 </a:t>
                      </a:r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 1.7</a:t>
                      </a:r>
                      <a:endParaRPr lang="en-GB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020683045"/>
                  </a:ext>
                </a:extLst>
              </a:tr>
            </a:tbl>
          </a:graphicData>
        </a:graphic>
      </p:graphicFrame>
      <p:graphicFrame>
        <p:nvGraphicFramePr>
          <p:cNvPr id="18" name="Objec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91563079"/>
              </p:ext>
            </p:extLst>
          </p:nvPr>
        </p:nvGraphicFramePr>
        <p:xfrm>
          <a:off x="267338" y="6266315"/>
          <a:ext cx="2868612" cy="18589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4311545" imgH="2796846" progId="Prism8.Document">
                  <p:embed/>
                </p:oleObj>
              </mc:Choice>
              <mc:Fallback>
                <p:oleObj name="Prism 8" r:id="rId8" imgW="4311545" imgH="2796846" progId="Prism8.Document">
                  <p:embed/>
                  <p:pic>
                    <p:nvPicPr>
                      <p:cNvPr id="18" name="Object 17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67338" y="6266315"/>
                        <a:ext cx="2868612" cy="18589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A5C96792-026D-5547-94A1-72AFEC1FA285}"/>
              </a:ext>
            </a:extLst>
          </p:cNvPr>
          <p:cNvSpPr txBox="1"/>
          <p:nvPr/>
        </p:nvSpPr>
        <p:spPr>
          <a:xfrm>
            <a:off x="121747" y="5982966"/>
            <a:ext cx="3712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</a:p>
        </p:txBody>
      </p:sp>
      <p:graphicFrame>
        <p:nvGraphicFramePr>
          <p:cNvPr id="20" name="Object 1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06719313"/>
              </p:ext>
            </p:extLst>
          </p:nvPr>
        </p:nvGraphicFramePr>
        <p:xfrm>
          <a:off x="3284538" y="6245225"/>
          <a:ext cx="2852737" cy="1901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0" imgW="4288496" imgH="2862375" progId="Prism8.Document">
                  <p:embed/>
                </p:oleObj>
              </mc:Choice>
              <mc:Fallback>
                <p:oleObj name="Prism 8" r:id="rId10" imgW="4288496" imgH="2862375" progId="Prism8.Document">
                  <p:embed/>
                  <p:pic>
                    <p:nvPicPr>
                      <p:cNvPr id="20" name="Object 19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284538" y="6245225"/>
                        <a:ext cx="2852737" cy="1901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83539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5">
            <a:extLst>
              <a:ext uri="{FF2B5EF4-FFF2-40B4-BE49-F238E27FC236}">
                <a16:creationId xmlns:a16="http://schemas.microsoft.com/office/drawing/2014/main" id="{DB56F4EA-9B61-D949-9D48-05DF63EF73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2570" y="3002509"/>
            <a:ext cx="7380515" cy="545508"/>
          </a:xfrm>
        </p:spPr>
        <p:txBody>
          <a:bodyPr>
            <a:no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. Definition of DLT in the phase I dose escalation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DLTs identified during the first cycle informed the decision to dose escalate through the increasing dose levels. A DLT was defined as an almost certainly or probably drug-related adverse event to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crizotinib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and/or PD-0325901.</a:t>
            </a:r>
            <a:b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45143" y="223030"/>
            <a:ext cx="7080704" cy="270843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marL="171450" lvl="0" indent="-171450">
              <a:buFont typeface="Arial" panose="020B0604020202020204" pitchFamily="34" charset="0"/>
              <a:buChar char="•"/>
            </a:pP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Neutropenia Grade 4 for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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5 days duration </a:t>
            </a:r>
          </a:p>
          <a:p>
            <a:pPr marL="171450" lvl="0" indent="-171450">
              <a:buFont typeface="Arial" panose="020B0604020202020204" pitchFamily="34" charset="0"/>
              <a:buChar char="•"/>
            </a:pP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Febrile neutropenia (without clinically or microbiologically documented infection) with an absolute neutrophil count  &lt;1000/mm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and a single temperature of &gt;38.3˚C or a sustained temperature of  ≥38˚C for more than one hour. </a:t>
            </a:r>
          </a:p>
          <a:p>
            <a:pPr marL="171450" lvl="0" indent="-171450">
              <a:buFont typeface="Arial" panose="020B0604020202020204" pitchFamily="34" charset="0"/>
              <a:buChar char="•"/>
            </a:pP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Infection (documented clinically or microbiologically) with Grade 3 or 4 neutropenia (ANC &lt;1.0 x 10</a:t>
            </a:r>
            <a:r>
              <a:rPr lang="en-GB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/L)</a:t>
            </a:r>
          </a:p>
          <a:p>
            <a:pPr marL="171450" lvl="0" indent="-171450">
              <a:buFont typeface="Arial" panose="020B0604020202020204" pitchFamily="34" charset="0"/>
              <a:buChar char="•"/>
            </a:pP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Thrombocytopenia Grade 4: </a:t>
            </a:r>
          </a:p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	a) for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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5 days duration, or </a:t>
            </a:r>
          </a:p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	b) associated with active bleeding, or </a:t>
            </a:r>
          </a:p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	c) requiring platelet transfusion.</a:t>
            </a:r>
          </a:p>
          <a:p>
            <a:pPr marL="171450" lvl="0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ymptomatic Grade 3 CPK elevation or Grade 4 asymptomatic CPK elevation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</a:p>
          <a:p>
            <a:pPr marL="171450" lvl="0" indent="-171450">
              <a:buFont typeface="Arial" panose="020B0604020202020204" pitchFamily="34" charset="0"/>
              <a:buChar char="•"/>
            </a:pP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Grade 3 or 4 toxicity to organs other than the bone marrow but including Grade 3 and Grade 4 biochemical AEs     	EXCLUDING:</a:t>
            </a:r>
          </a:p>
          <a:p>
            <a:pPr lvl="1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Grade 3 nausea in patients who have not received optimal treatment with anti-emetics</a:t>
            </a:r>
          </a:p>
          <a:p>
            <a:pPr lvl="1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Grade 3 or 4 vomiting in patients who have not received optimal treatment with anti-emetics</a:t>
            </a:r>
          </a:p>
          <a:p>
            <a:pPr lvl="1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Grade 3 or 4 diarrhoea in patients who have not received optimal treatment with anti-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diarrhoeals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and Grade 2 diarrhoea for more than 7 days in patients who have received optimal treatment with anti-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diarrhoeals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lvl="1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Grade 3 fatigue, unless there is an increase by at least two grades from baseline</a:t>
            </a:r>
          </a:p>
          <a:p>
            <a:pPr marL="171450" lvl="0" indent="-171450">
              <a:buFont typeface="Arial" panose="020B0604020202020204" pitchFamily="34" charset="0"/>
              <a:buChar char="•"/>
            </a:pP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AE with a fatal outcome</a:t>
            </a:r>
          </a:p>
        </p:txBody>
      </p:sp>
    </p:spTree>
    <p:extLst>
      <p:ext uri="{BB962C8B-B14F-4D97-AF65-F5344CB8AC3E}">
        <p14:creationId xmlns:p14="http://schemas.microsoft.com/office/powerpoint/2010/main" val="9120063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D71D897E-2354-5641-82FB-5CB9DDACF13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3467551"/>
              </p:ext>
            </p:extLst>
          </p:nvPr>
        </p:nvGraphicFramePr>
        <p:xfrm>
          <a:off x="150325" y="152152"/>
          <a:ext cx="6001758" cy="2690748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1846595">
                  <a:extLst>
                    <a:ext uri="{9D8B030D-6E8A-4147-A177-3AD203B41FA5}">
                      <a16:colId xmlns:a16="http://schemas.microsoft.com/office/drawing/2014/main" val="3000328497"/>
                    </a:ext>
                  </a:extLst>
                </a:gridCol>
                <a:gridCol w="1002470">
                  <a:extLst>
                    <a:ext uri="{9D8B030D-6E8A-4147-A177-3AD203B41FA5}">
                      <a16:colId xmlns:a16="http://schemas.microsoft.com/office/drawing/2014/main" val="2187575203"/>
                    </a:ext>
                  </a:extLst>
                </a:gridCol>
                <a:gridCol w="977511">
                  <a:extLst>
                    <a:ext uri="{9D8B030D-6E8A-4147-A177-3AD203B41FA5}">
                      <a16:colId xmlns:a16="http://schemas.microsoft.com/office/drawing/2014/main" val="2299845107"/>
                    </a:ext>
                  </a:extLst>
                </a:gridCol>
                <a:gridCol w="783404">
                  <a:extLst>
                    <a:ext uri="{9D8B030D-6E8A-4147-A177-3AD203B41FA5}">
                      <a16:colId xmlns:a16="http://schemas.microsoft.com/office/drawing/2014/main" val="246017585"/>
                    </a:ext>
                  </a:extLst>
                </a:gridCol>
                <a:gridCol w="783404">
                  <a:extLst>
                    <a:ext uri="{9D8B030D-6E8A-4147-A177-3AD203B41FA5}">
                      <a16:colId xmlns:a16="http://schemas.microsoft.com/office/drawing/2014/main" val="4078109364"/>
                    </a:ext>
                  </a:extLst>
                </a:gridCol>
                <a:gridCol w="608374">
                  <a:extLst>
                    <a:ext uri="{9D8B030D-6E8A-4147-A177-3AD203B41FA5}">
                      <a16:colId xmlns:a16="http://schemas.microsoft.com/office/drawing/2014/main" val="3290303600"/>
                    </a:ext>
                  </a:extLst>
                </a:gridCol>
              </a:tblGrid>
              <a:tr h="75177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 of patients affecte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-0325901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izotinib</a:t>
                      </a:r>
                      <a:endParaRPr lang="en-GB" sz="1000" b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, (%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ort 1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mg B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0mg O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6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ort 2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mg B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mg B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5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ort 3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mg B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mg B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6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ort 4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mg B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mg B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7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24)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92906360"/>
                  </a:ext>
                </a:extLst>
              </a:tr>
              <a:tr h="93133">
                <a:tc gridSpan="6"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AE</a:t>
                      </a:r>
                    </a:p>
                  </a:txBody>
                  <a:tcPr marL="68580" marR="68580" marT="0" marB="0"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6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2842114"/>
                  </a:ext>
                </a:extLst>
              </a:tr>
              <a:tr h="138203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dominal infection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6.7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4.2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16351509"/>
                  </a:ext>
                </a:extLst>
              </a:tr>
              <a:tr h="138203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onic obstruction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6.7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4.2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26670343"/>
                  </a:ext>
                </a:extLst>
              </a:tr>
              <a:tr h="138203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yspnoea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6.7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4.2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79203934"/>
                  </a:ext>
                </a:extLst>
              </a:tr>
              <a:tr h="126261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ver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6.7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4.3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8.3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49115767"/>
                  </a:ext>
                </a:extLst>
              </a:tr>
              <a:tr h="138203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albuminemia 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6.7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4.2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84492481"/>
                  </a:ext>
                </a:extLst>
              </a:tr>
              <a:tr h="138203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teonecrosis of jaw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 (20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4.2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28990897"/>
                  </a:ext>
                </a:extLst>
              </a:tr>
              <a:tr h="276407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acute abdominal obstruction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6.7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4.2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91470990"/>
                  </a:ext>
                </a:extLst>
              </a:tr>
              <a:tr h="90593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ound infection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6.7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</a:t>
                      </a: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4.2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97405643"/>
                  </a:ext>
                </a:extLst>
              </a:tr>
              <a:tr h="90593">
                <a:tc gridSpan="6"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LT                                                (n=6)                   (n=5)                 (n=4)</a:t>
                      </a:r>
                      <a:r>
                        <a:rPr lang="en-GB" sz="1000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             (n=6)       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      (n=21)</a:t>
                      </a:r>
                    </a:p>
                  </a:txBody>
                  <a:tcPr marL="68580" marR="68580" marT="0" marB="0"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6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7210773"/>
                  </a:ext>
                </a:extLst>
              </a:tr>
              <a:tr h="90593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atigue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16.7)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4.7)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01904783"/>
                  </a:ext>
                </a:extLst>
              </a:tr>
            </a:tbl>
          </a:graphicData>
        </a:graphic>
      </p:graphicFrame>
      <p:sp>
        <p:nvSpPr>
          <p:cNvPr id="8" name="Title 5">
            <a:extLst>
              <a:ext uri="{FF2B5EF4-FFF2-40B4-BE49-F238E27FC236}">
                <a16:creationId xmlns:a16="http://schemas.microsoft.com/office/drawing/2014/main" id="{72CCBBB3-056B-0A45-BC52-0B13A2B27B4B}"/>
              </a:ext>
            </a:extLst>
          </p:cNvPr>
          <p:cNvSpPr txBox="1">
            <a:spLocks/>
          </p:cNvSpPr>
          <p:nvPr/>
        </p:nvSpPr>
        <p:spPr>
          <a:xfrm>
            <a:off x="67341" y="2935608"/>
            <a:ext cx="6179839" cy="29123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2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Serious Adverse Events (SAEs) and Dose Limiting Toxicities (DLTs) experienced by patients in Cohort 1-4 who started treatment.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95312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>
            <a:extLst>
              <a:ext uri="{FF2B5EF4-FFF2-40B4-BE49-F238E27FC236}">
                <a16:creationId xmlns:a16="http://schemas.microsoft.com/office/drawing/2014/main" id="{DB56F4EA-9B61-D949-9D48-05DF63EF73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70789" y="5093898"/>
            <a:ext cx="5837911" cy="418966"/>
          </a:xfrm>
        </p:spPr>
        <p:txBody>
          <a:bodyPr>
            <a:noAutofit/>
          </a:bodyPr>
          <a:lstStyle/>
          <a:p>
            <a:pPr algn="just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3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Summary of treatment related non-hematologic and non-biochemical, biochemical and haematological adverse events (AE) of any grade experienced by ≥2 patients who commenced treatment in Cohorts 1-4.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BF75975A-EBE2-6E40-B1A7-19102748B9A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18432148"/>
              </p:ext>
            </p:extLst>
          </p:nvPr>
        </p:nvGraphicFramePr>
        <p:xfrm>
          <a:off x="350800" y="236032"/>
          <a:ext cx="5757900" cy="4811911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1807302">
                  <a:extLst>
                    <a:ext uri="{9D8B030D-6E8A-4147-A177-3AD203B41FA5}">
                      <a16:colId xmlns:a16="http://schemas.microsoft.com/office/drawing/2014/main" val="3689014672"/>
                    </a:ext>
                  </a:extLst>
                </a:gridCol>
                <a:gridCol w="828249">
                  <a:extLst>
                    <a:ext uri="{9D8B030D-6E8A-4147-A177-3AD203B41FA5}">
                      <a16:colId xmlns:a16="http://schemas.microsoft.com/office/drawing/2014/main" val="2248443885"/>
                    </a:ext>
                  </a:extLst>
                </a:gridCol>
                <a:gridCol w="779116">
                  <a:extLst>
                    <a:ext uri="{9D8B030D-6E8A-4147-A177-3AD203B41FA5}">
                      <a16:colId xmlns:a16="http://schemas.microsoft.com/office/drawing/2014/main" val="2037695574"/>
                    </a:ext>
                  </a:extLst>
                </a:gridCol>
                <a:gridCol w="765077">
                  <a:extLst>
                    <a:ext uri="{9D8B030D-6E8A-4147-A177-3AD203B41FA5}">
                      <a16:colId xmlns:a16="http://schemas.microsoft.com/office/drawing/2014/main" val="2835018393"/>
                    </a:ext>
                  </a:extLst>
                </a:gridCol>
                <a:gridCol w="789078">
                  <a:extLst>
                    <a:ext uri="{9D8B030D-6E8A-4147-A177-3AD203B41FA5}">
                      <a16:colId xmlns:a16="http://schemas.microsoft.com/office/drawing/2014/main" val="330078867"/>
                    </a:ext>
                  </a:extLst>
                </a:gridCol>
                <a:gridCol w="789078">
                  <a:extLst>
                    <a:ext uri="{9D8B030D-6E8A-4147-A177-3AD203B41FA5}">
                      <a16:colId xmlns:a16="http://schemas.microsoft.com/office/drawing/2014/main" val="1280355455"/>
                    </a:ext>
                  </a:extLst>
                </a:gridCol>
              </a:tblGrid>
              <a:tr h="408458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 of patients AE affecte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-0325901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izotinib</a:t>
                      </a:r>
                      <a:endParaRPr lang="en-GB" sz="1000" b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, (%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ort 1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mg B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0mg O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6)</a:t>
                      </a:r>
                      <a:endParaRPr lang="en-GB" sz="1000" b="0" i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ort 2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mg B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mg B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5)</a:t>
                      </a:r>
                      <a:endParaRPr lang="en-GB" sz="1000" b="0" i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ort 3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mg B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mg B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6)</a:t>
                      </a:r>
                      <a:endParaRPr lang="en-GB" sz="1000" b="0" i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ort 4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mg B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346710" algn="ctr"/>
                        </a:tabLs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mg B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7)</a:t>
                      </a:r>
                      <a:endParaRPr lang="en-GB" sz="1000" b="0" i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24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78879798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N-HAEMATOLOGICAL AND NON-BIOCHEMICAL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3260010520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ash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 (67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 (10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 (83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 (86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 (83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3924416748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ry skin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17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2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8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3479478746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onstipation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17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14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8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2486502652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iarrhoea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33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4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17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 (43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 (33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832298214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ausea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 (67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4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33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14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 (38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3504649796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Vomiting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33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4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17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29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 (29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305467755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ucositis (including mouth pain and ulcers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33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2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33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 (21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1127303113"/>
                  </a:ext>
                </a:extLst>
              </a:tr>
              <a:tr h="208564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norexia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33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2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14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 (17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3174802198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atigue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33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2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33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 (43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 (33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1406214880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edema 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33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33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29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 (25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919066470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Visual disturbance (including blurred vision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33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17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14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 (17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192127101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QTc prolongation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17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2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17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14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 (17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445883943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CHEMICAL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29603093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LP increase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2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17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8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420742680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LT increase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2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17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8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3245722501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Hypoalbuminaemia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33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2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33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 (21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1391535206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HAEMATOLOGICAL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2571538853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aemia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33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 (5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 (21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152021742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912870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5">
            <a:extLst>
              <a:ext uri="{FF2B5EF4-FFF2-40B4-BE49-F238E27FC236}">
                <a16:creationId xmlns:a16="http://schemas.microsoft.com/office/drawing/2014/main" id="{9F209C75-D5F8-8342-9BD6-FD64922338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3786" y="5302250"/>
            <a:ext cx="5861511" cy="465668"/>
          </a:xfrm>
        </p:spPr>
        <p:txBody>
          <a:bodyPr>
            <a:noAutofit/>
          </a:bodyPr>
          <a:lstStyle/>
          <a:p>
            <a:pPr algn="just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4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Grade 3-4 treatment related non-hematologic and non-biochemical, biochemical and haematological adverse events (AE) experienced by patients who commenced treatment in Cohorts 1-4.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03E19869-43B1-6544-8627-800AD326DC0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56538997"/>
              </p:ext>
            </p:extLst>
          </p:nvPr>
        </p:nvGraphicFramePr>
        <p:xfrm>
          <a:off x="499987" y="345162"/>
          <a:ext cx="5785311" cy="4916831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1815906">
                  <a:extLst>
                    <a:ext uri="{9D8B030D-6E8A-4147-A177-3AD203B41FA5}">
                      <a16:colId xmlns:a16="http://schemas.microsoft.com/office/drawing/2014/main" val="3689014672"/>
                    </a:ext>
                  </a:extLst>
                </a:gridCol>
                <a:gridCol w="832192">
                  <a:extLst>
                    <a:ext uri="{9D8B030D-6E8A-4147-A177-3AD203B41FA5}">
                      <a16:colId xmlns:a16="http://schemas.microsoft.com/office/drawing/2014/main" val="2248443885"/>
                    </a:ext>
                  </a:extLst>
                </a:gridCol>
                <a:gridCol w="782825">
                  <a:extLst>
                    <a:ext uri="{9D8B030D-6E8A-4147-A177-3AD203B41FA5}">
                      <a16:colId xmlns:a16="http://schemas.microsoft.com/office/drawing/2014/main" val="2037695574"/>
                    </a:ext>
                  </a:extLst>
                </a:gridCol>
                <a:gridCol w="768720">
                  <a:extLst>
                    <a:ext uri="{9D8B030D-6E8A-4147-A177-3AD203B41FA5}">
                      <a16:colId xmlns:a16="http://schemas.microsoft.com/office/drawing/2014/main" val="2835018393"/>
                    </a:ext>
                  </a:extLst>
                </a:gridCol>
                <a:gridCol w="792834">
                  <a:extLst>
                    <a:ext uri="{9D8B030D-6E8A-4147-A177-3AD203B41FA5}">
                      <a16:colId xmlns:a16="http://schemas.microsoft.com/office/drawing/2014/main" val="330078867"/>
                    </a:ext>
                  </a:extLst>
                </a:gridCol>
                <a:gridCol w="792834">
                  <a:extLst>
                    <a:ext uri="{9D8B030D-6E8A-4147-A177-3AD203B41FA5}">
                      <a16:colId xmlns:a16="http://schemas.microsoft.com/office/drawing/2014/main" val="3714947645"/>
                    </a:ext>
                  </a:extLst>
                </a:gridCol>
              </a:tblGrid>
              <a:tr h="408458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 of patients AE affecte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-0325901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izotinib</a:t>
                      </a:r>
                      <a:endParaRPr lang="en-GB" sz="1000" b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, (%)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ort 1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mg B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0mg O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6)</a:t>
                      </a:r>
                      <a:endParaRPr lang="en-GB" sz="1000" b="0" i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ort 2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mg B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mg B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5)</a:t>
                      </a:r>
                      <a:endParaRPr lang="en-GB" sz="1000" b="0" i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ort 3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mg B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mg B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6)</a:t>
                      </a:r>
                      <a:endParaRPr lang="en-GB" sz="1000" b="0" i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ort 4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mg B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346710" algn="ctr"/>
                        </a:tabLs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mg B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7)</a:t>
                      </a:r>
                      <a:endParaRPr lang="en-GB" sz="1000" b="0" i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 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i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24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78879798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N-HAEMATOLOGICAL AND NON-BIOCHEMICAL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3260010520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ash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3924416748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bdominal pain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17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4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3479478746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sthenia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2486502652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onstipation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832298214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iarrhoea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3504649796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atigue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17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17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8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305467755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norexia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1127303113"/>
                  </a:ext>
                </a:extLst>
              </a:tr>
              <a:tr h="208564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ausea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3174802198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ymphoedema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17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4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1406214880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aronychia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919066470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QTc prolongation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192127101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Visual disturbance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445883943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Vomiting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17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4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29603093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andibular pain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2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4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3970905398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CHEMICAL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420742680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 err="1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Hypoalbuminaemia</a:t>
                      </a:r>
                      <a:endParaRPr lang="en-GB" sz="1000" b="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33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8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1461524890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DH increase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3245722501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HAEMATOLOGICAL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1391535206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naemia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17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 (17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8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1612459929"/>
                  </a:ext>
                </a:extLst>
              </a:tr>
              <a:tr h="194029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hrombocytopenia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 (0)</a:t>
                      </a:r>
                    </a:p>
                  </a:txBody>
                  <a:tcPr marL="65614" marR="65614" marT="0" marB="0"/>
                </a:tc>
                <a:extLst>
                  <a:ext uri="{0D108BD9-81ED-4DB2-BD59-A6C34878D82A}">
                    <a16:rowId xmlns:a16="http://schemas.microsoft.com/office/drawing/2014/main" val="257153885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41539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96B93476-AC2D-BD4F-B749-555D818759D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56333420"/>
              </p:ext>
            </p:extLst>
          </p:nvPr>
        </p:nvGraphicFramePr>
        <p:xfrm>
          <a:off x="476906" y="359986"/>
          <a:ext cx="6564866" cy="6923040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2280731">
                  <a:extLst>
                    <a:ext uri="{9D8B030D-6E8A-4147-A177-3AD203B41FA5}">
                      <a16:colId xmlns:a16="http://schemas.microsoft.com/office/drawing/2014/main" val="3732240802"/>
                    </a:ext>
                  </a:extLst>
                </a:gridCol>
                <a:gridCol w="1083734">
                  <a:extLst>
                    <a:ext uri="{9D8B030D-6E8A-4147-A177-3AD203B41FA5}">
                      <a16:colId xmlns:a16="http://schemas.microsoft.com/office/drawing/2014/main" val="2059807058"/>
                    </a:ext>
                  </a:extLst>
                </a:gridCol>
                <a:gridCol w="1058333">
                  <a:extLst>
                    <a:ext uri="{9D8B030D-6E8A-4147-A177-3AD203B41FA5}">
                      <a16:colId xmlns:a16="http://schemas.microsoft.com/office/drawing/2014/main" val="57815133"/>
                    </a:ext>
                  </a:extLst>
                </a:gridCol>
                <a:gridCol w="1066801">
                  <a:extLst>
                    <a:ext uri="{9D8B030D-6E8A-4147-A177-3AD203B41FA5}">
                      <a16:colId xmlns:a16="http://schemas.microsoft.com/office/drawing/2014/main" val="3391252581"/>
                    </a:ext>
                  </a:extLst>
                </a:gridCol>
                <a:gridCol w="1075267">
                  <a:extLst>
                    <a:ext uri="{9D8B030D-6E8A-4147-A177-3AD203B41FA5}">
                      <a16:colId xmlns:a16="http://schemas.microsoft.com/office/drawing/2014/main" val="3253377215"/>
                    </a:ext>
                  </a:extLst>
                </a:gridCol>
              </a:tblGrid>
              <a:tr h="742062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ort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-0325901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izotinib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ort 1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mg B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0mg O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= 6</a:t>
                      </a: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ort 2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mg B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mg B.D</a:t>
                      </a:r>
                    </a:p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= 5</a:t>
                      </a: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ort 3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mg B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mg B.D</a:t>
                      </a:r>
                    </a:p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= 5</a:t>
                      </a: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ort 4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mg B.D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mg B.D</a:t>
                      </a:r>
                    </a:p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= 6</a:t>
                      </a: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GB" sz="1000" b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7167" marR="67167" marT="0" marB="0"/>
                </a:tc>
                <a:extLst>
                  <a:ext uri="{0D108BD9-81ED-4DB2-BD59-A6C34878D82A}">
                    <a16:rowId xmlns:a16="http://schemas.microsoft.com/office/drawing/2014/main" val="4055446545"/>
                  </a:ext>
                </a:extLst>
              </a:tr>
              <a:tr h="210451">
                <a:tc gridSpan="5"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rizotinib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7167" marR="67167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1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7167" marR="67167" marT="0" marB="0"/>
                </a:tc>
                <a:extLst>
                  <a:ext uri="{0D108BD9-81ED-4DB2-BD59-A6C34878D82A}">
                    <a16:rowId xmlns:a16="http://schemas.microsoft.com/office/drawing/2014/main" val="1588605309"/>
                  </a:ext>
                </a:extLst>
              </a:tr>
              <a:tr h="910767">
                <a:tc>
                  <a:txBody>
                    <a:bodyPr/>
                    <a:lstStyle/>
                    <a:p>
                      <a:pPr marL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cle 1, Day 21</a:t>
                      </a:r>
                    </a:p>
                    <a:p>
                      <a:pPr marL="18000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GB" sz="1000" b="0" baseline="-250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ax</a:t>
                      </a: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, ng/ml (SD)</a:t>
                      </a:r>
                    </a:p>
                    <a:p>
                      <a:pPr marL="18000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GB" sz="1000" b="0" baseline="-25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in</a:t>
                      </a: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, ng/ml (SD)</a:t>
                      </a:r>
                    </a:p>
                    <a:p>
                      <a:pPr marL="18000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</a:t>
                      </a:r>
                      <a:r>
                        <a:rPr lang="en-GB" sz="1000" b="0" baseline="-250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ax</a:t>
                      </a: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, h (SD)</a:t>
                      </a:r>
                    </a:p>
                    <a:p>
                      <a:pPr marL="18000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UC</a:t>
                      </a:r>
                      <a:r>
                        <a:rPr lang="en-GB" sz="1000" b="0" baseline="-25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-10h</a:t>
                      </a: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, ng*h/ml (SD)</a:t>
                      </a:r>
                    </a:p>
                    <a:p>
                      <a:pPr marL="18000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UC</a:t>
                      </a:r>
                      <a:r>
                        <a:rPr lang="en-GB" sz="1000" b="0" baseline="-25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-24h</a:t>
                      </a: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,</a:t>
                      </a:r>
                      <a:r>
                        <a:rPr lang="en-GB" sz="1000" b="0" baseline="-25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g*h/ml (SD)</a:t>
                      </a: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0 (81.3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5 (64.4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0 (1.26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41 (688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612 (1325)</a:t>
                      </a:r>
                      <a:endParaRPr lang="en-GB" sz="1000" b="0" baseline="-25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000" b="0" baseline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0 (53.9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86 (55.8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.21 (1.76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115 (448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D</a:t>
                      </a: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000" baseline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35 (35.3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2 (43.6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.33 (1.15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34 (397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D</a:t>
                      </a: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000" baseline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69 (157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3 (121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48 (1.01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336 (1414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D</a:t>
                      </a:r>
                    </a:p>
                  </a:txBody>
                  <a:tcPr marL="67167" marR="67167" marT="0" marB="0"/>
                </a:tc>
                <a:extLst>
                  <a:ext uri="{0D108BD9-81ED-4DB2-BD59-A6C34878D82A}">
                    <a16:rowId xmlns:a16="http://schemas.microsoft.com/office/drawing/2014/main" val="137622200"/>
                  </a:ext>
                </a:extLst>
              </a:tr>
              <a:tr h="882588"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cle 1, Day 28</a:t>
                      </a:r>
                    </a:p>
                    <a:p>
                      <a:pPr marL="18000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GB" sz="1000" b="0" baseline="-250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ax</a:t>
                      </a: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, ng/ml (SD)</a:t>
                      </a:r>
                    </a:p>
                    <a:p>
                      <a:pPr marL="18000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GB" sz="1000" b="0" baseline="-25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in</a:t>
                      </a: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, ng/ml (SD)</a:t>
                      </a:r>
                    </a:p>
                    <a:p>
                      <a:pPr marL="18000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</a:t>
                      </a:r>
                      <a:r>
                        <a:rPr lang="en-GB" sz="1000" b="0" baseline="-250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ax</a:t>
                      </a: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, h (SD)</a:t>
                      </a:r>
                    </a:p>
                    <a:p>
                      <a:pPr marL="18000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UC</a:t>
                      </a:r>
                      <a:r>
                        <a:rPr lang="en-GB" sz="1000" b="0" baseline="-25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-10h</a:t>
                      </a: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, ng*h/ml (SD)</a:t>
                      </a:r>
                    </a:p>
                    <a:p>
                      <a:pPr marL="18000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UC</a:t>
                      </a:r>
                      <a:r>
                        <a:rPr lang="en-GB" sz="1000" b="0" baseline="-25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-24h</a:t>
                      </a: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, ng*h/ml (SD)</a:t>
                      </a:r>
                      <a:endParaRPr lang="en-GB" sz="1000" b="0" baseline="-25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000" b="0" baseline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4 (59.8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9 (44.4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58 (2.36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78 (567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987 (1233)</a:t>
                      </a: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000" b="0" baseline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81 (118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83 (66.3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76 (1.5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358 (905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D</a:t>
                      </a: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000" baseline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41 (133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59 (96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67 (1.15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919 (1207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D</a:t>
                      </a: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000" baseline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75 (105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11 (78.6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58 (0.96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402 (873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D</a:t>
                      </a:r>
                    </a:p>
                  </a:txBody>
                  <a:tcPr marL="67167" marR="67167" marT="0" marB="0"/>
                </a:tc>
                <a:extLst>
                  <a:ext uri="{0D108BD9-81ED-4DB2-BD59-A6C34878D82A}">
                    <a16:rowId xmlns:a16="http://schemas.microsoft.com/office/drawing/2014/main" val="3210670358"/>
                  </a:ext>
                </a:extLst>
              </a:tr>
              <a:tr h="208499">
                <a:tc gridSpan="5">
                  <a:txBody>
                    <a:bodyPr/>
                    <a:lstStyle/>
                    <a:p>
                      <a:pPr marL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D-0325901</a:t>
                      </a:r>
                    </a:p>
                  </a:txBody>
                  <a:tcPr marL="67167" marR="67167" marT="0" marB="0" anchor="ctr"/>
                </a:tc>
                <a:tc hMerge="1"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100" b="0" baseline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7167" marR="67167" marT="0" marB="0"/>
                </a:tc>
                <a:tc hMerge="1"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100" b="0" baseline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7167" marR="67167" marT="0" marB="0"/>
                </a:tc>
                <a:tc hMerge="1"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100" baseline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7167" marR="67167" marT="0" marB="0"/>
                </a:tc>
                <a:tc hMerge="1"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100" baseline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7167" marR="67167" marT="0" marB="0"/>
                </a:tc>
                <a:extLst>
                  <a:ext uri="{0D108BD9-81ED-4DB2-BD59-A6C34878D82A}">
                    <a16:rowId xmlns:a16="http://schemas.microsoft.com/office/drawing/2014/main" val="42020773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cle 1, Day -1</a:t>
                      </a:r>
                    </a:p>
                    <a:p>
                      <a:pPr marL="18000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GB" sz="1000" b="0" baseline="-250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ax</a:t>
                      </a: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,</a:t>
                      </a: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g/ml (SD)</a:t>
                      </a:r>
                    </a:p>
                    <a:p>
                      <a:pPr marL="18000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GB" sz="1000" b="0" baseline="-25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in</a:t>
                      </a: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, ng/ml (SD)</a:t>
                      </a:r>
                    </a:p>
                    <a:p>
                      <a:pPr marL="18000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</a:t>
                      </a:r>
                      <a:r>
                        <a:rPr lang="en-GB" sz="1000" b="0" baseline="-250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ax</a:t>
                      </a: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, h (SD)</a:t>
                      </a:r>
                    </a:p>
                    <a:p>
                      <a:pPr marL="18000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UC</a:t>
                      </a:r>
                      <a:r>
                        <a:rPr lang="en-GB" sz="1000" b="0" baseline="-25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-10h</a:t>
                      </a: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ng*h/ml (SD)</a:t>
                      </a: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000" b="0" baseline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7.8 (41.9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3.6 (9.3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16 (1.94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00 (117)</a:t>
                      </a: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000" b="0" baseline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9 (50.5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8.7 (5.83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20 (0.46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2 (129)</a:t>
                      </a: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000" baseline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26 (66.1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7.9 (5.89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02 (0.04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96 (120)</a:t>
                      </a: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000" baseline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84 (84.1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9.2 (24.3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36 (0.5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907 (254)</a:t>
                      </a:r>
                    </a:p>
                  </a:txBody>
                  <a:tcPr marL="67167" marR="67167" marT="0" marB="0"/>
                </a:tc>
                <a:extLst>
                  <a:ext uri="{0D108BD9-81ED-4DB2-BD59-A6C34878D82A}">
                    <a16:rowId xmlns:a16="http://schemas.microsoft.com/office/drawing/2014/main" val="3224658086"/>
                  </a:ext>
                </a:extLst>
              </a:tr>
              <a:tr h="374866">
                <a:tc>
                  <a:txBody>
                    <a:bodyPr/>
                    <a:lstStyle/>
                    <a:p>
                      <a:pPr marL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cle 1, Day 21</a:t>
                      </a:r>
                    </a:p>
                    <a:p>
                      <a:pPr marL="18000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GB" sz="1000" b="0" baseline="-250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ax</a:t>
                      </a: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,</a:t>
                      </a: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g/ml (SD)</a:t>
                      </a:r>
                    </a:p>
                    <a:p>
                      <a:pPr marL="18000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GB" sz="1000" b="0" baseline="-25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in</a:t>
                      </a: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, ng/ml (SD)</a:t>
                      </a:r>
                    </a:p>
                    <a:p>
                      <a:pPr marL="18000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</a:t>
                      </a:r>
                      <a:r>
                        <a:rPr lang="en-GB" sz="1000" b="0" baseline="-250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ax</a:t>
                      </a: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, h (SD)</a:t>
                      </a:r>
                    </a:p>
                    <a:p>
                      <a:pPr marL="18000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UC</a:t>
                      </a:r>
                      <a:r>
                        <a:rPr lang="en-GB" sz="1000" b="0" baseline="-25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-10h</a:t>
                      </a: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ng*h/ml (SD)</a:t>
                      </a: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000" b="0" baseline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0.3 (43.1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6.0 (16.1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19 (0.97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00 (160)</a:t>
                      </a: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000" b="0" baseline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2.3 (34.7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.6 (3.12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65 (0.56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1 (106)</a:t>
                      </a: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000" baseline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5 (36.2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5.8 (13.3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67 (0.58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83 (51.7)</a:t>
                      </a: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000" baseline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19 (93.6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5.4 (13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27 (1.25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62 (190)</a:t>
                      </a:r>
                    </a:p>
                  </a:txBody>
                  <a:tcPr marL="67167" marR="67167" marT="0" marB="0"/>
                </a:tc>
                <a:extLst>
                  <a:ext uri="{0D108BD9-81ED-4DB2-BD59-A6C34878D82A}">
                    <a16:rowId xmlns:a16="http://schemas.microsoft.com/office/drawing/2014/main" val="1655722858"/>
                  </a:ext>
                </a:extLst>
              </a:tr>
              <a:tr h="243240">
                <a:tc gridSpan="5">
                  <a:txBody>
                    <a:bodyPr/>
                    <a:lstStyle/>
                    <a:p>
                      <a:pPr marL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D-0315209</a:t>
                      </a:r>
                    </a:p>
                  </a:txBody>
                  <a:tcPr marL="67167" marR="67167" marT="0" marB="0" anchor="ctr"/>
                </a:tc>
                <a:tc hMerge="1"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100" b="0" baseline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7167" marR="67167" marT="0" marB="0"/>
                </a:tc>
                <a:tc hMerge="1"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100" b="0" baseline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7167" marR="67167" marT="0" marB="0"/>
                </a:tc>
                <a:tc hMerge="1"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100" baseline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7167" marR="67167" marT="0" marB="0"/>
                </a:tc>
                <a:tc hMerge="1"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100" baseline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7167" marR="67167" marT="0" marB="0"/>
                </a:tc>
                <a:extLst>
                  <a:ext uri="{0D108BD9-81ED-4DB2-BD59-A6C34878D82A}">
                    <a16:rowId xmlns:a16="http://schemas.microsoft.com/office/drawing/2014/main" val="2112081468"/>
                  </a:ext>
                </a:extLst>
              </a:tr>
              <a:tr h="374866">
                <a:tc>
                  <a:txBody>
                    <a:bodyPr/>
                    <a:lstStyle/>
                    <a:p>
                      <a:pPr marL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cle 1, Day -1</a:t>
                      </a:r>
                    </a:p>
                    <a:p>
                      <a:pPr marL="18000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GB" sz="1000" b="0" baseline="-250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ax</a:t>
                      </a: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,</a:t>
                      </a: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g/ml (SD)</a:t>
                      </a:r>
                    </a:p>
                    <a:p>
                      <a:pPr marL="18000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GB" sz="1000" b="0" baseline="-25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in</a:t>
                      </a: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, ng/ml (SD)</a:t>
                      </a:r>
                    </a:p>
                    <a:p>
                      <a:pPr marL="18000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</a:t>
                      </a:r>
                      <a:r>
                        <a:rPr lang="en-GB" sz="1000" b="0" baseline="-250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ax</a:t>
                      </a: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, h (SD)</a:t>
                      </a:r>
                    </a:p>
                    <a:p>
                      <a:pPr marL="18000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UC</a:t>
                      </a:r>
                      <a:r>
                        <a:rPr lang="en-GB" sz="1000" b="0" baseline="-25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-10h</a:t>
                      </a: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ng*h/ml (SD)</a:t>
                      </a: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000" b="0" baseline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3.1 (30.7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4.0 (29.6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33 (3.38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98 (304)</a:t>
                      </a: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000" b="0" baseline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9.4 (35.3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0.4 (26.3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61 (0.54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08 (318)</a:t>
                      </a: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000" baseline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7 (44.3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9.4 (22.7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02 (0.04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54 (301)</a:t>
                      </a: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000" baseline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95 (55.6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7 (47.4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83 (0.41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26 (501)</a:t>
                      </a:r>
                    </a:p>
                  </a:txBody>
                  <a:tcPr marL="67167" marR="67167" marT="0" marB="0"/>
                </a:tc>
                <a:extLst>
                  <a:ext uri="{0D108BD9-81ED-4DB2-BD59-A6C34878D82A}">
                    <a16:rowId xmlns:a16="http://schemas.microsoft.com/office/drawing/2014/main" val="2249449710"/>
                  </a:ext>
                </a:extLst>
              </a:tr>
              <a:tr h="374866">
                <a:tc>
                  <a:txBody>
                    <a:bodyPr/>
                    <a:lstStyle/>
                    <a:p>
                      <a:pPr marL="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cle 1, Day 21</a:t>
                      </a:r>
                    </a:p>
                    <a:p>
                      <a:pPr marL="18000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GB" sz="1000" b="0" baseline="-250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ax</a:t>
                      </a: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,</a:t>
                      </a: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g/ml (SD)</a:t>
                      </a:r>
                    </a:p>
                    <a:p>
                      <a:pPr marL="180000" marR="0" lvl="0" indent="0" algn="just" defTabSz="75593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GB" sz="1000" b="0" baseline="-25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in</a:t>
                      </a: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, ng/ml (SD)</a:t>
                      </a:r>
                    </a:p>
                    <a:p>
                      <a:pPr marL="18000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</a:t>
                      </a:r>
                      <a:r>
                        <a:rPr lang="en-GB" sz="1000" b="0" baseline="-250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ax</a:t>
                      </a: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, h (SD)</a:t>
                      </a:r>
                    </a:p>
                    <a:p>
                      <a:pPr marL="180000"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UC</a:t>
                      </a:r>
                      <a:r>
                        <a:rPr lang="en-GB" sz="1000" b="0" baseline="-25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-10h</a:t>
                      </a: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ng*h/ml (SD)</a:t>
                      </a: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000" b="0" baseline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2.0 (24.8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1.3 (23.3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.52 (1.20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87 (22.6)</a:t>
                      </a: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000" b="0" baseline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6.7 (29.5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7.3 (25.4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25 (1.09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13 (273)</a:t>
                      </a: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000" baseline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3 (40.5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6.6 (18.8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.03 (2.69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31 (246)</a:t>
                      </a:r>
                    </a:p>
                  </a:txBody>
                  <a:tcPr marL="67167" marR="67167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1000" baseline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7 (57.6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3.1 (31.7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00 (2.83)</a:t>
                      </a: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92 (228)</a:t>
                      </a:r>
                    </a:p>
                  </a:txBody>
                  <a:tcPr marL="67167" marR="67167" marT="0" marB="0"/>
                </a:tc>
                <a:extLst>
                  <a:ext uri="{0D108BD9-81ED-4DB2-BD59-A6C34878D82A}">
                    <a16:rowId xmlns:a16="http://schemas.microsoft.com/office/drawing/2014/main" val="2503274748"/>
                  </a:ext>
                </a:extLst>
              </a:tr>
            </a:tbl>
          </a:graphicData>
        </a:graphic>
      </p:graphicFrame>
      <p:sp>
        <p:nvSpPr>
          <p:cNvPr id="4" name="Title 5">
            <a:extLst>
              <a:ext uri="{FF2B5EF4-FFF2-40B4-BE49-F238E27FC236}">
                <a16:creationId xmlns:a16="http://schemas.microsoft.com/office/drawing/2014/main" id="{4EDAF3AA-DA65-5947-8926-5B68D952E7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00919" y="7323034"/>
            <a:ext cx="6640853" cy="786807"/>
          </a:xfrm>
        </p:spPr>
        <p:txBody>
          <a:bodyPr>
            <a:noAutofit/>
          </a:bodyPr>
          <a:lstStyle/>
          <a:p>
            <a:pPr algn="just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5. Pharmacokinetic parameters during dose escalation for PD-0325901 with </a:t>
            </a:r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rizotinib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for each cohort as measured during cycle 1.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0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max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= observed maximum concentration post-dose;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0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= observed maximum concentration post-dose;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GB" sz="10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max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= time to reach maximum concentration in hours; </a:t>
            </a:r>
            <a:r>
              <a:rPr lang="en-GB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UC</a:t>
            </a:r>
            <a:r>
              <a:rPr lang="en-GB" sz="1000" baseline="-25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0-10h </a:t>
            </a:r>
            <a:r>
              <a:rPr lang="en-GB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area under concentration-time curve to the last data point at 10h; </a:t>
            </a:r>
            <a:r>
              <a:rPr lang="en-GB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UC</a:t>
            </a:r>
            <a:r>
              <a:rPr lang="en-GB" sz="1000" baseline="-25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0-24h </a:t>
            </a:r>
            <a:r>
              <a:rPr lang="en-GB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area under concentration-time curve to the last data point at 24h. ND = not determined. PD-0315209 = carboxylic acid metabolite of PD-0325901.</a:t>
            </a:r>
          </a:p>
        </p:txBody>
      </p:sp>
    </p:spTree>
    <p:extLst>
      <p:ext uri="{BB962C8B-B14F-4D97-AF65-F5344CB8AC3E}">
        <p14:creationId xmlns:p14="http://schemas.microsoft.com/office/powerpoint/2010/main" val="29753500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3CA1116C06665458E7F7EDC6469099E" ma:contentTypeVersion="4" ma:contentTypeDescription="Create a new document." ma:contentTypeScope="" ma:versionID="df9a7a834dc9b980cdf4ad33a9df9793">
  <xsd:schema xmlns:xsd="http://www.w3.org/2001/XMLSchema" xmlns:xs="http://www.w3.org/2001/XMLSchema" xmlns:p="http://schemas.microsoft.com/office/2006/metadata/properties" xmlns:ns2="b16e0201-c55c-4ab4-9fb7-7edf2adb091d" targetNamespace="http://schemas.microsoft.com/office/2006/metadata/properties" ma:root="true" ma:fieldsID="7babf85bfde3fab84c19a49f959624b6" ns2:_="">
    <xsd:import namespace="b16e0201-c55c-4ab4-9fb7-7edf2adb091d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16e0201-c55c-4ab4-9fb7-7edf2adb091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95D34B67-539E-4B51-9776-1244929D311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b16e0201-c55c-4ab4-9fb7-7edf2adb091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930FFFD3-7B13-4DF5-8DFE-C3247A9BD3AE}">
  <ds:schemaRefs>
    <ds:schemaRef ds:uri="http://purl.org/dc/elements/1.1/"/>
    <ds:schemaRef ds:uri="http://schemas.microsoft.com/office/2006/metadata/properties"/>
    <ds:schemaRef ds:uri="b16e0201-c55c-4ab4-9fb7-7edf2adb091d"/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1FE6A65C-46BE-47D4-8F77-E30DB7F665BE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773</TotalTime>
  <Words>2889</Words>
  <Application>Microsoft Office PowerPoint</Application>
  <PresentationFormat>Custom</PresentationFormat>
  <Paragraphs>670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rism 8</vt:lpstr>
      <vt:lpstr>PowerPoint Presentation</vt:lpstr>
      <vt:lpstr>PowerPoint Presentation</vt:lpstr>
      <vt:lpstr>Supplementary table 1. Definition of DLT in the phase I dose escalation. DLTs identified during the first cycle informed the decision to dose escalate through the increasing dose levels. A DLT was defined as an almost certainly or probably drug-related adverse event to crizotinib and/or PD-0325901. </vt:lpstr>
      <vt:lpstr>PowerPoint Presentation</vt:lpstr>
      <vt:lpstr>Supplementary table 3. Summary of treatment related non-hematologic and non-biochemical, biochemical and haematological adverse events (AE) of any grade experienced by ≥2 patients who commenced treatment in Cohorts 1-4.</vt:lpstr>
      <vt:lpstr>Supplementary table 4. Grade 3-4 treatment related non-hematologic and non-biochemical, biochemical and haematological adverse events (AE) experienced by patients who commenced treatment in Cohorts 1-4.</vt:lpstr>
      <vt:lpstr>Supplementary table 5. Pharmacokinetic parameters during dose escalation for PD-0325901 with Crizotinib for each cohort as measured during cycle 1. Cmax = observed maximum concentration post-dose; Cmin = observed maximum concentration post-dose; Tmax = time to reach maximum concentration in hours; AUC0-10h = area under concentration-time curve to the last data point at 10h; AUC0-24h = area under concentration-time curve to the last data point at 24h. ND = not determined. PD-0315209 = carboxylic acid metabolite of PD-0325901.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F Gallagher</dc:creator>
  <cp:lastModifiedBy>Sandra Van Schaeybroeck</cp:lastModifiedBy>
  <cp:revision>243</cp:revision>
  <cp:lastPrinted>2021-01-10T11:20:40Z</cp:lastPrinted>
  <dcterms:created xsi:type="dcterms:W3CDTF">2019-12-14T16:46:03Z</dcterms:created>
  <dcterms:modified xsi:type="dcterms:W3CDTF">2024-12-02T17:32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3CA1116C06665458E7F7EDC6469099E</vt:lpwstr>
  </property>
</Properties>
</file>